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20"/>
  </p:notesMasterIdLst>
  <p:sldIdLst>
    <p:sldId id="258" r:id="rId2"/>
    <p:sldId id="261" r:id="rId3"/>
    <p:sldId id="260" r:id="rId4"/>
    <p:sldId id="268" r:id="rId5"/>
    <p:sldId id="265" r:id="rId6"/>
    <p:sldId id="262" r:id="rId7"/>
    <p:sldId id="269" r:id="rId8"/>
    <p:sldId id="274" r:id="rId9"/>
    <p:sldId id="263" r:id="rId10"/>
    <p:sldId id="266" r:id="rId11"/>
    <p:sldId id="273" r:id="rId12"/>
    <p:sldId id="264" r:id="rId13"/>
    <p:sldId id="267" r:id="rId14"/>
    <p:sldId id="271" r:id="rId15"/>
    <p:sldId id="272" r:id="rId16"/>
    <p:sldId id="256" r:id="rId17"/>
    <p:sldId id="259" r:id="rId18"/>
    <p:sldId id="257" r:id="rId19"/>
  </p:sldIdLst>
  <p:sldSz cx="12192000" cy="6858000"/>
  <p:notesSz cx="6858000" cy="9144000"/>
  <p:defaultTextStyle>
    <a:defPPr>
      <a:defRPr lang="en-P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7008"/>
    <p:restoredTop sz="94694"/>
  </p:normalViewPr>
  <p:slideViewPr>
    <p:cSldViewPr snapToGrid="0">
      <p:cViewPr varScale="1">
        <p:scale>
          <a:sx n="91" d="100"/>
          <a:sy n="91" d="100"/>
        </p:scale>
        <p:origin x="192" y="8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presProps" Target="pres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notesMaster" Target="notesMasters/notesMaster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tableStyles" Target="tableStyle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theme" Target="theme/theme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PT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DE8F105-F6A9-8D40-B5F2-01010B3A0DA5}" type="datetimeFigureOut">
              <a:rPr lang="en-PT" smtClean="0"/>
              <a:t>17/09/2025</a:t>
            </a:fld>
            <a:endParaRPr lang="en-PT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PT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P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P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82213A2-A72C-BD4C-A757-55A019A64861}" type="slidenum">
              <a:rPr lang="en-PT" smtClean="0"/>
              <a:t>‹#›</a:t>
            </a:fld>
            <a:endParaRPr lang="en-PT"/>
          </a:p>
        </p:txBody>
      </p:sp>
    </p:spTree>
    <p:extLst>
      <p:ext uri="{BB962C8B-B14F-4D97-AF65-F5344CB8AC3E}">
        <p14:creationId xmlns:p14="http://schemas.microsoft.com/office/powerpoint/2010/main" val="331083383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dirty="0"/>
              <a:t>M</a:t>
            </a:r>
            <a:r>
              <a:rPr lang="en-PT" dirty="0"/>
              <a:t>ocks not attached her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0495BD9-6181-A844-A9B5-04AC2666A17F}" type="slidenum">
              <a:rPr lang="en-PT" smtClean="0"/>
              <a:t>2</a:t>
            </a:fld>
            <a:endParaRPr lang="en-PT"/>
          </a:p>
        </p:txBody>
      </p:sp>
    </p:spTree>
    <p:extLst>
      <p:ext uri="{BB962C8B-B14F-4D97-AF65-F5344CB8AC3E}">
        <p14:creationId xmlns:p14="http://schemas.microsoft.com/office/powerpoint/2010/main" val="268234594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dirty="0"/>
              <a:t>M</a:t>
            </a:r>
            <a:r>
              <a:rPr lang="en-PT" dirty="0"/>
              <a:t>ocks not attached her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0495BD9-6181-A844-A9B5-04AC2666A17F}" type="slidenum">
              <a:rPr lang="en-PT" smtClean="0"/>
              <a:t>9</a:t>
            </a:fld>
            <a:endParaRPr lang="en-PT"/>
          </a:p>
        </p:txBody>
      </p:sp>
    </p:spTree>
    <p:extLst>
      <p:ext uri="{BB962C8B-B14F-4D97-AF65-F5344CB8AC3E}">
        <p14:creationId xmlns:p14="http://schemas.microsoft.com/office/powerpoint/2010/main" val="247392880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PT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0495BD9-6181-A844-A9B5-04AC2666A17F}" type="slidenum">
              <a:rPr lang="en-PT" smtClean="0"/>
              <a:t>12</a:t>
            </a:fld>
            <a:endParaRPr lang="en-PT"/>
          </a:p>
        </p:txBody>
      </p:sp>
    </p:spTree>
    <p:extLst>
      <p:ext uri="{BB962C8B-B14F-4D97-AF65-F5344CB8AC3E}">
        <p14:creationId xmlns:p14="http://schemas.microsoft.com/office/powerpoint/2010/main" val="200407087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F39B19-F5EC-430E-7B83-6AE4098E8F3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PT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CA50D9E-699D-FCE4-517E-AC4E76C0ECA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PT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9EB01DB-338A-73F7-5A5B-897782D139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4C44DA-2120-CE43-925E-9174F3C636A2}" type="datetimeFigureOut">
              <a:rPr lang="en-PT" smtClean="0"/>
              <a:t>17/09/2025</a:t>
            </a:fld>
            <a:endParaRPr lang="en-P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72A0211-45AD-F0BC-4958-D994AB90DD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FE973AC-A508-4CF9-92AF-7D66B5F11F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B8DF21-F4E1-A844-9136-A41894589A2A}" type="slidenum">
              <a:rPr lang="en-PT" smtClean="0"/>
              <a:t>‹#›</a:t>
            </a:fld>
            <a:endParaRPr lang="en-PT"/>
          </a:p>
        </p:txBody>
      </p:sp>
    </p:spTree>
    <p:extLst>
      <p:ext uri="{BB962C8B-B14F-4D97-AF65-F5344CB8AC3E}">
        <p14:creationId xmlns:p14="http://schemas.microsoft.com/office/powerpoint/2010/main" val="10051543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530335-4AF5-536B-216E-A99A6831BEE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PT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7877792-7722-5BC5-4EE2-1A4514DC4C1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PT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E2BA01A-29C1-8C20-7308-FAF0EAEE09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4C44DA-2120-CE43-925E-9174F3C636A2}" type="datetimeFigureOut">
              <a:rPr lang="en-PT" smtClean="0"/>
              <a:t>17/09/2025</a:t>
            </a:fld>
            <a:endParaRPr lang="en-P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EFE695F-989C-6A36-3E3B-ECE755F304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3F2DC7F-9B87-2172-EBF4-3DF5EDF72D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B8DF21-F4E1-A844-9136-A41894589A2A}" type="slidenum">
              <a:rPr lang="en-PT" smtClean="0"/>
              <a:t>‹#›</a:t>
            </a:fld>
            <a:endParaRPr lang="en-PT"/>
          </a:p>
        </p:txBody>
      </p:sp>
    </p:spTree>
    <p:extLst>
      <p:ext uri="{BB962C8B-B14F-4D97-AF65-F5344CB8AC3E}">
        <p14:creationId xmlns:p14="http://schemas.microsoft.com/office/powerpoint/2010/main" val="949632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F534EBC-0302-AD15-A8E3-A7C10B9D921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PT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0C8D812-897F-0AFC-15EF-8D1DE3DEBC3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PT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453CAD6-4A22-F334-DD1F-4ABC12F6D0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4C44DA-2120-CE43-925E-9174F3C636A2}" type="datetimeFigureOut">
              <a:rPr lang="en-PT" smtClean="0"/>
              <a:t>17/09/2025</a:t>
            </a:fld>
            <a:endParaRPr lang="en-P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FD49653-D711-0AFC-C2EC-2ADB05BEAE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9F14B47-CC41-A0FC-527B-F929F659F3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B8DF21-F4E1-A844-9136-A41894589A2A}" type="slidenum">
              <a:rPr lang="en-PT" smtClean="0"/>
              <a:t>‹#›</a:t>
            </a:fld>
            <a:endParaRPr lang="en-PT"/>
          </a:p>
        </p:txBody>
      </p:sp>
    </p:spTree>
    <p:extLst>
      <p:ext uri="{BB962C8B-B14F-4D97-AF65-F5344CB8AC3E}">
        <p14:creationId xmlns:p14="http://schemas.microsoft.com/office/powerpoint/2010/main" val="31254101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CAA642-C497-B1CE-A484-672F7381F10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PT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281AF7B-B87F-34E0-BE4B-FCDECC9FEEE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PT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E74B6DC-8C22-AE5A-2CD6-C4C7A8BBB7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4C44DA-2120-CE43-925E-9174F3C636A2}" type="datetimeFigureOut">
              <a:rPr lang="en-PT" smtClean="0"/>
              <a:t>17/09/2025</a:t>
            </a:fld>
            <a:endParaRPr lang="en-P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8D2A13D-0055-D217-B8E7-631CA94D2F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E22602F-62C5-40F2-1A75-233D8606DB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B8DF21-F4E1-A844-9136-A41894589A2A}" type="slidenum">
              <a:rPr lang="en-PT" smtClean="0"/>
              <a:t>‹#›</a:t>
            </a:fld>
            <a:endParaRPr lang="en-PT"/>
          </a:p>
        </p:txBody>
      </p:sp>
    </p:spTree>
    <p:extLst>
      <p:ext uri="{BB962C8B-B14F-4D97-AF65-F5344CB8AC3E}">
        <p14:creationId xmlns:p14="http://schemas.microsoft.com/office/powerpoint/2010/main" val="1941429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A2CE25-3D5A-CF2E-C018-88CF3CEFDD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PT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C0078DC-8E0B-D9B6-0A6E-FE30B78CC6F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4EEC878-C4E7-1B9F-9869-44F296E5B7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4C44DA-2120-CE43-925E-9174F3C636A2}" type="datetimeFigureOut">
              <a:rPr lang="en-PT" smtClean="0"/>
              <a:t>17/09/2025</a:t>
            </a:fld>
            <a:endParaRPr lang="en-P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8BEF2D6-5F4C-BEEC-3259-A0B81B292E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AF08405-D526-34AF-2CEB-749FFE5F5A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B8DF21-F4E1-A844-9136-A41894589A2A}" type="slidenum">
              <a:rPr lang="en-PT" smtClean="0"/>
              <a:t>‹#›</a:t>
            </a:fld>
            <a:endParaRPr lang="en-PT"/>
          </a:p>
        </p:txBody>
      </p:sp>
    </p:spTree>
    <p:extLst>
      <p:ext uri="{BB962C8B-B14F-4D97-AF65-F5344CB8AC3E}">
        <p14:creationId xmlns:p14="http://schemas.microsoft.com/office/powerpoint/2010/main" val="12736327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40ECEE-C34C-CE51-E099-9EA2B20E32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PT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EA7E88E-8F52-8589-CB89-0BF7649D12B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PT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A4F4803-51FA-0CA9-220F-A69C2E55C3B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PT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3DAABC0-8625-4D04-832A-206828928A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4C44DA-2120-CE43-925E-9174F3C636A2}" type="datetimeFigureOut">
              <a:rPr lang="en-PT" smtClean="0"/>
              <a:t>17/09/2025</a:t>
            </a:fld>
            <a:endParaRPr lang="en-PT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43741E6-2FC6-6664-DDCB-D5AD4D610B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T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12759AE-2783-EDD2-4B72-053439EC12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B8DF21-F4E1-A844-9136-A41894589A2A}" type="slidenum">
              <a:rPr lang="en-PT" smtClean="0"/>
              <a:t>‹#›</a:t>
            </a:fld>
            <a:endParaRPr lang="en-PT"/>
          </a:p>
        </p:txBody>
      </p:sp>
    </p:spTree>
    <p:extLst>
      <p:ext uri="{BB962C8B-B14F-4D97-AF65-F5344CB8AC3E}">
        <p14:creationId xmlns:p14="http://schemas.microsoft.com/office/powerpoint/2010/main" val="38915143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1DFE62-064B-5CAC-2785-7D9EEB86AC8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PT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7C97E23-0136-2339-1FAF-4F169FBBE93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E3150B7-88D2-78BF-1B09-FAC1F127586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PT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EC07EED-9BE0-B93E-331B-354AD29D825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6A0C703-C16A-B322-1A6A-90847FAEEF7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PT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2B153FB-1341-BF72-0D47-5EB6685764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4C44DA-2120-CE43-925E-9174F3C636A2}" type="datetimeFigureOut">
              <a:rPr lang="en-PT" smtClean="0"/>
              <a:t>17/09/2025</a:t>
            </a:fld>
            <a:endParaRPr lang="en-PT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9C29F34-C3B5-FD1F-2E62-FE704F17DF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T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C8E1941-6501-6766-5D7D-4E50B12274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B8DF21-F4E1-A844-9136-A41894589A2A}" type="slidenum">
              <a:rPr lang="en-PT" smtClean="0"/>
              <a:t>‹#›</a:t>
            </a:fld>
            <a:endParaRPr lang="en-PT"/>
          </a:p>
        </p:txBody>
      </p:sp>
    </p:spTree>
    <p:extLst>
      <p:ext uri="{BB962C8B-B14F-4D97-AF65-F5344CB8AC3E}">
        <p14:creationId xmlns:p14="http://schemas.microsoft.com/office/powerpoint/2010/main" val="14919112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AA6B91-296D-266E-EE81-6675BCD8E20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PT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7463102-E2FA-0486-21D6-7BCA93AD81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4C44DA-2120-CE43-925E-9174F3C636A2}" type="datetimeFigureOut">
              <a:rPr lang="en-PT" smtClean="0"/>
              <a:t>17/09/2025</a:t>
            </a:fld>
            <a:endParaRPr lang="en-PT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A3BC7EF-DC83-19DB-3B9D-D694C79163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T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971216D-D9DE-25BA-5BC6-B430478EF8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B8DF21-F4E1-A844-9136-A41894589A2A}" type="slidenum">
              <a:rPr lang="en-PT" smtClean="0"/>
              <a:t>‹#›</a:t>
            </a:fld>
            <a:endParaRPr lang="en-PT"/>
          </a:p>
        </p:txBody>
      </p:sp>
    </p:spTree>
    <p:extLst>
      <p:ext uri="{BB962C8B-B14F-4D97-AF65-F5344CB8AC3E}">
        <p14:creationId xmlns:p14="http://schemas.microsoft.com/office/powerpoint/2010/main" val="8825870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B22BBE6-5F84-3F18-EC3F-317C142C17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4C44DA-2120-CE43-925E-9174F3C636A2}" type="datetimeFigureOut">
              <a:rPr lang="en-PT" smtClean="0"/>
              <a:t>17/09/2025</a:t>
            </a:fld>
            <a:endParaRPr lang="en-PT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07B411D-A5E4-3E4E-9D38-639B4406DE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T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D265BD3-50CD-A72A-3A6F-EAB6DF3123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B8DF21-F4E1-A844-9136-A41894589A2A}" type="slidenum">
              <a:rPr lang="en-PT" smtClean="0"/>
              <a:t>‹#›</a:t>
            </a:fld>
            <a:endParaRPr lang="en-PT"/>
          </a:p>
        </p:txBody>
      </p:sp>
    </p:spTree>
    <p:extLst>
      <p:ext uri="{BB962C8B-B14F-4D97-AF65-F5344CB8AC3E}">
        <p14:creationId xmlns:p14="http://schemas.microsoft.com/office/powerpoint/2010/main" val="29334611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84D4C4A-DB9E-CC19-D5D6-BB64FD57906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PT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39B259F-E96B-EBE9-0674-DC4613AD344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PT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8286D4E-2338-8E01-0549-DC3ED901363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EA38ABD-A66D-9950-1630-BB9FDFF30B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4C44DA-2120-CE43-925E-9174F3C636A2}" type="datetimeFigureOut">
              <a:rPr lang="en-PT" smtClean="0"/>
              <a:t>17/09/2025</a:t>
            </a:fld>
            <a:endParaRPr lang="en-PT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0B46C77-F64A-0AEC-687B-642E01B888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T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7A64411-A471-707F-8FC9-D2376787A7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B8DF21-F4E1-A844-9136-A41894589A2A}" type="slidenum">
              <a:rPr lang="en-PT" smtClean="0"/>
              <a:t>‹#›</a:t>
            </a:fld>
            <a:endParaRPr lang="en-PT"/>
          </a:p>
        </p:txBody>
      </p:sp>
    </p:spTree>
    <p:extLst>
      <p:ext uri="{BB962C8B-B14F-4D97-AF65-F5344CB8AC3E}">
        <p14:creationId xmlns:p14="http://schemas.microsoft.com/office/powerpoint/2010/main" val="40348754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252671-F015-D013-AFF6-8B839FF114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PT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FAB51F8-43C7-BA8E-7560-22BC1F09DD1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PT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25BBEF7-BFFF-4C86-59C5-2A053C80FF7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42DE5FC-593B-D945-4123-EFE504DF88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4C44DA-2120-CE43-925E-9174F3C636A2}" type="datetimeFigureOut">
              <a:rPr lang="en-PT" smtClean="0"/>
              <a:t>17/09/2025</a:t>
            </a:fld>
            <a:endParaRPr lang="en-PT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8468BFD-1276-10F9-1488-F092F73EAF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T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37C3733-6F3D-F3E6-D803-4407DB11FB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B8DF21-F4E1-A844-9136-A41894589A2A}" type="slidenum">
              <a:rPr lang="en-PT" smtClean="0"/>
              <a:t>‹#›</a:t>
            </a:fld>
            <a:endParaRPr lang="en-PT"/>
          </a:p>
        </p:txBody>
      </p:sp>
    </p:spTree>
    <p:extLst>
      <p:ext uri="{BB962C8B-B14F-4D97-AF65-F5344CB8AC3E}">
        <p14:creationId xmlns:p14="http://schemas.microsoft.com/office/powerpoint/2010/main" val="42778978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B1E4D5F-70A4-56E6-F5F3-502FD3A99F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PT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B08133E-0BF9-6E53-90BB-D0F5DC2E588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PT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296FBAB-C96E-FFDE-701F-07822F574B1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04C44DA-2120-CE43-925E-9174F3C636A2}" type="datetimeFigureOut">
              <a:rPr lang="en-PT" smtClean="0"/>
              <a:t>17/09/2025</a:t>
            </a:fld>
            <a:endParaRPr lang="en-P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D72AD49-383D-9EED-F0F5-FFF80BFE095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P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524A822-385A-19E6-A27A-4A76B0F6AE6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5B8DF21-F4E1-A844-9136-A41894589A2A}" type="slidenum">
              <a:rPr lang="en-PT" smtClean="0"/>
              <a:t>‹#›</a:t>
            </a:fld>
            <a:endParaRPr lang="en-PT"/>
          </a:p>
        </p:txBody>
      </p:sp>
    </p:spTree>
    <p:extLst>
      <p:ext uri="{BB962C8B-B14F-4D97-AF65-F5344CB8AC3E}">
        <p14:creationId xmlns:p14="http://schemas.microsoft.com/office/powerpoint/2010/main" val="7342891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P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7.png"/><Relationship Id="rId2" Type="http://schemas.openxmlformats.org/officeDocument/2006/relationships/image" Target="../media/image36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9.png"/><Relationship Id="rId2" Type="http://schemas.openxmlformats.org/officeDocument/2006/relationships/image" Target="../media/image38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8" Type="http://schemas.openxmlformats.org/officeDocument/2006/relationships/image" Target="../media/image45.png"/><Relationship Id="rId3" Type="http://schemas.openxmlformats.org/officeDocument/2006/relationships/image" Target="../media/image40.png"/><Relationship Id="rId7" Type="http://schemas.openxmlformats.org/officeDocument/2006/relationships/image" Target="../media/image44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3.png"/><Relationship Id="rId5" Type="http://schemas.openxmlformats.org/officeDocument/2006/relationships/image" Target="../media/image42.png"/><Relationship Id="rId10" Type="http://schemas.openxmlformats.org/officeDocument/2006/relationships/image" Target="../media/image47.png"/><Relationship Id="rId4" Type="http://schemas.openxmlformats.org/officeDocument/2006/relationships/image" Target="../media/image41.png"/><Relationship Id="rId9" Type="http://schemas.openxmlformats.org/officeDocument/2006/relationships/image" Target="../media/image46.png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8.pn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9.png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1.png"/><Relationship Id="rId2" Type="http://schemas.openxmlformats.org/officeDocument/2006/relationships/image" Target="../media/image50.png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52.png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54.png"/><Relationship Id="rId2" Type="http://schemas.openxmlformats.org/officeDocument/2006/relationships/image" Target="../media/image53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7" Type="http://schemas.openxmlformats.org/officeDocument/2006/relationships/image" Target="../media/image17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6.png"/><Relationship Id="rId5" Type="http://schemas.openxmlformats.org/officeDocument/2006/relationships/image" Target="../media/image15.png"/><Relationship Id="rId4" Type="http://schemas.openxmlformats.org/officeDocument/2006/relationships/image" Target="../media/image14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27.png"/><Relationship Id="rId13" Type="http://schemas.openxmlformats.org/officeDocument/2006/relationships/image" Target="../media/image32.png"/><Relationship Id="rId3" Type="http://schemas.openxmlformats.org/officeDocument/2006/relationships/image" Target="../media/image22.png"/><Relationship Id="rId7" Type="http://schemas.openxmlformats.org/officeDocument/2006/relationships/image" Target="../media/image26.png"/><Relationship Id="rId12" Type="http://schemas.openxmlformats.org/officeDocument/2006/relationships/image" Target="../media/image31.png"/><Relationship Id="rId2" Type="http://schemas.openxmlformats.org/officeDocument/2006/relationships/notesSlide" Target="../notesSlides/notesSlide2.xml"/><Relationship Id="rId16" Type="http://schemas.openxmlformats.org/officeDocument/2006/relationships/image" Target="../media/image3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5.png"/><Relationship Id="rId11" Type="http://schemas.openxmlformats.org/officeDocument/2006/relationships/image" Target="../media/image30.png"/><Relationship Id="rId5" Type="http://schemas.openxmlformats.org/officeDocument/2006/relationships/image" Target="../media/image24.png"/><Relationship Id="rId15" Type="http://schemas.openxmlformats.org/officeDocument/2006/relationships/image" Target="../media/image34.png"/><Relationship Id="rId10" Type="http://schemas.openxmlformats.org/officeDocument/2006/relationships/image" Target="../media/image29.png"/><Relationship Id="rId4" Type="http://schemas.openxmlformats.org/officeDocument/2006/relationships/image" Target="../media/image23.png"/><Relationship Id="rId9" Type="http://schemas.openxmlformats.org/officeDocument/2006/relationships/image" Target="../media/image28.png"/><Relationship Id="rId14" Type="http://schemas.openxmlformats.org/officeDocument/2006/relationships/image" Target="../media/image3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8CFCFE-5F5C-62C1-D3A5-62728FDDD3FC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PT" dirty="0"/>
              <a:t>A549 cell line WBs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6C23BFB-3E2A-3275-0916-84A10210E011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PT"/>
          </a:p>
        </p:txBody>
      </p:sp>
    </p:spTree>
    <p:extLst>
      <p:ext uri="{BB962C8B-B14F-4D97-AF65-F5344CB8AC3E}">
        <p14:creationId xmlns:p14="http://schemas.microsoft.com/office/powerpoint/2010/main" val="156019189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B94BEF-73E6-10AD-46C7-0958B30B4C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PT" dirty="0"/>
              <a:t>Replicate 1					Replicate 2</a:t>
            </a:r>
          </a:p>
        </p:txBody>
      </p:sp>
      <p:pic>
        <p:nvPicPr>
          <p:cNvPr id="5" name="Content Placeholder 4" descr="A close-up of a dna test&#10;&#10;AI-generated content may be incorrect.">
            <a:extLst>
              <a:ext uri="{FF2B5EF4-FFF2-40B4-BE49-F238E27FC236}">
                <a16:creationId xmlns:a16="http://schemas.microsoft.com/office/drawing/2014/main" id="{FC2A13CD-7AF1-776C-8764-69DE0A6DBA1F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771634" y="1661785"/>
            <a:ext cx="5324366" cy="4647540"/>
          </a:xfr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5F0D7EFB-AB1C-94E3-A4E5-DB32D1988DCA}"/>
              </a:ext>
            </a:extLst>
          </p:cNvPr>
          <p:cNvSpPr txBox="1"/>
          <p:nvPr/>
        </p:nvSpPr>
        <p:spPr>
          <a:xfrm>
            <a:off x="210208" y="5381297"/>
            <a:ext cx="8379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17 kd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7464D7F-C8CE-CC1C-D376-7E2C75DE7EED}"/>
              </a:ext>
            </a:extLst>
          </p:cNvPr>
          <p:cNvSpPr txBox="1"/>
          <p:nvPr/>
        </p:nvSpPr>
        <p:spPr>
          <a:xfrm>
            <a:off x="210208" y="4548301"/>
            <a:ext cx="8379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25 kd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3322248E-B09C-1AC9-476E-763E6ECC10B8}"/>
              </a:ext>
            </a:extLst>
          </p:cNvPr>
          <p:cNvSpPr txBox="1"/>
          <p:nvPr/>
        </p:nvSpPr>
        <p:spPr>
          <a:xfrm>
            <a:off x="198278" y="3630674"/>
            <a:ext cx="8379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48 kd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FB951A7-A4FF-A22D-2B2E-2EC712137B1E}"/>
              </a:ext>
            </a:extLst>
          </p:cNvPr>
          <p:cNvSpPr txBox="1"/>
          <p:nvPr/>
        </p:nvSpPr>
        <p:spPr>
          <a:xfrm>
            <a:off x="210208" y="4827649"/>
            <a:ext cx="8379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20 kd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8F58E61-3ADF-F3F2-782A-76AE8290CADF}"/>
              </a:ext>
            </a:extLst>
          </p:cNvPr>
          <p:cNvSpPr txBox="1"/>
          <p:nvPr/>
        </p:nvSpPr>
        <p:spPr>
          <a:xfrm>
            <a:off x="210208" y="4039295"/>
            <a:ext cx="8379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35 kd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10876EF2-4EAC-4687-DF62-CA9CAB08CBAA}"/>
              </a:ext>
            </a:extLst>
          </p:cNvPr>
          <p:cNvSpPr txBox="1"/>
          <p:nvPr/>
        </p:nvSpPr>
        <p:spPr>
          <a:xfrm>
            <a:off x="210208" y="3290245"/>
            <a:ext cx="8379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63 kda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1D8CCA7A-CF6E-BD8D-65C1-32ACB7C6F298}"/>
              </a:ext>
            </a:extLst>
          </p:cNvPr>
          <p:cNvSpPr txBox="1"/>
          <p:nvPr/>
        </p:nvSpPr>
        <p:spPr>
          <a:xfrm>
            <a:off x="148492" y="2781239"/>
            <a:ext cx="9614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100 kd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6B3C923F-2DEC-C60C-1BAC-47CDF825292F}"/>
              </a:ext>
            </a:extLst>
          </p:cNvPr>
          <p:cNvSpPr txBox="1"/>
          <p:nvPr/>
        </p:nvSpPr>
        <p:spPr>
          <a:xfrm>
            <a:off x="1555531" y="6309325"/>
            <a:ext cx="25188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PB2, NP, actin, NS1, M2</a:t>
            </a:r>
          </a:p>
        </p:txBody>
      </p:sp>
      <p:pic>
        <p:nvPicPr>
          <p:cNvPr id="15" name="Picture 14" descr="A close-up of a dna test&#10;&#10;AI-generated content may be incorrect.">
            <a:extLst>
              <a:ext uri="{FF2B5EF4-FFF2-40B4-BE49-F238E27FC236}">
                <a16:creationId xmlns:a16="http://schemas.microsoft.com/office/drawing/2014/main" id="{EE05A274-9978-B449-BBCE-281111A90D0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29435" y="2031118"/>
            <a:ext cx="5324365" cy="4647539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FC5710A0-B136-D3E5-63B3-C6EF4BAC0A2D}"/>
              </a:ext>
            </a:extLst>
          </p:cNvPr>
          <p:cNvSpPr txBox="1"/>
          <p:nvPr/>
        </p:nvSpPr>
        <p:spPr>
          <a:xfrm>
            <a:off x="7432169" y="6308209"/>
            <a:ext cx="25188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PB2, NP, actin, NS1, M2</a:t>
            </a:r>
          </a:p>
        </p:txBody>
      </p:sp>
    </p:spTree>
    <p:extLst>
      <p:ext uri="{BB962C8B-B14F-4D97-AF65-F5344CB8AC3E}">
        <p14:creationId xmlns:p14="http://schemas.microsoft.com/office/powerpoint/2010/main" val="2432237032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F19638-C202-322E-44D4-D726D49E24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PT" dirty="0"/>
              <a:t>M1</a:t>
            </a:r>
          </a:p>
        </p:txBody>
      </p:sp>
      <p:pic>
        <p:nvPicPr>
          <p:cNvPr id="5" name="Content Placeholder 4" descr="A close-up of a dna test&#10;&#10;AI-generated content may be incorrect.">
            <a:extLst>
              <a:ext uri="{FF2B5EF4-FFF2-40B4-BE49-F238E27FC236}">
                <a16:creationId xmlns:a16="http://schemas.microsoft.com/office/drawing/2014/main" id="{B3080DC8-132E-2800-E9C5-F80C670496B4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838200" y="3003269"/>
            <a:ext cx="4929554" cy="2464777"/>
          </a:xfr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252804B9-F1A9-16FA-E1E7-9216CC645C48}"/>
              </a:ext>
            </a:extLst>
          </p:cNvPr>
          <p:cNvSpPr txBox="1"/>
          <p:nvPr/>
        </p:nvSpPr>
        <p:spPr>
          <a:xfrm>
            <a:off x="456435" y="3672987"/>
            <a:ext cx="4908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M1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FA0946C8-290A-9E7F-495F-3BB764AED478}"/>
              </a:ext>
            </a:extLst>
          </p:cNvPr>
          <p:cNvSpPr txBox="1"/>
          <p:nvPr/>
        </p:nvSpPr>
        <p:spPr>
          <a:xfrm>
            <a:off x="211015" y="4698609"/>
            <a:ext cx="4908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M2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0EDA4ED-8286-2A0D-1561-111C57338FF8}"/>
              </a:ext>
            </a:extLst>
          </p:cNvPr>
          <p:cNvSpPr txBox="1"/>
          <p:nvPr/>
        </p:nvSpPr>
        <p:spPr>
          <a:xfrm>
            <a:off x="251568" y="3866325"/>
            <a:ext cx="7914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25kd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90BF349-D551-0D3F-F505-D53871573ADB}"/>
              </a:ext>
            </a:extLst>
          </p:cNvPr>
          <p:cNvSpPr txBox="1"/>
          <p:nvPr/>
        </p:nvSpPr>
        <p:spPr>
          <a:xfrm>
            <a:off x="2082018" y="2644726"/>
            <a:ext cx="13532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R1 12h, 16h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32E3F63-8836-19AB-BABD-D4BEDE3016FE}"/>
              </a:ext>
            </a:extLst>
          </p:cNvPr>
          <p:cNvSpPr txBox="1"/>
          <p:nvPr/>
        </p:nvSpPr>
        <p:spPr>
          <a:xfrm>
            <a:off x="7748954" y="2644726"/>
            <a:ext cx="13532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R2 12h, 16h</a:t>
            </a:r>
          </a:p>
        </p:txBody>
      </p:sp>
      <p:pic>
        <p:nvPicPr>
          <p:cNvPr id="12" name="Picture 11" descr="A close-up of a dna test&#10;&#10;AI-generated content may be incorrect.">
            <a:extLst>
              <a:ext uri="{FF2B5EF4-FFF2-40B4-BE49-F238E27FC236}">
                <a16:creationId xmlns:a16="http://schemas.microsoft.com/office/drawing/2014/main" id="{5FB842DD-D199-9FDC-112F-0C50DD6BC00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52684" y="3313523"/>
            <a:ext cx="4280910" cy="214045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81953158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C590F4-59E3-25C8-2E7E-7D179ADDCB4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6200" y="18255"/>
            <a:ext cx="10515600" cy="1325563"/>
          </a:xfrm>
        </p:spPr>
        <p:txBody>
          <a:bodyPr>
            <a:normAutofit/>
          </a:bodyPr>
          <a:lstStyle/>
          <a:p>
            <a:r>
              <a:rPr lang="en-PT" sz="3600" dirty="0"/>
              <a:t>Replicate 3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6755BA1B-6DE2-286B-99E3-F5CA485246EE}"/>
              </a:ext>
            </a:extLst>
          </p:cNvPr>
          <p:cNvSpPr txBox="1"/>
          <p:nvPr/>
        </p:nvSpPr>
        <p:spPr>
          <a:xfrm>
            <a:off x="7066868" y="1416813"/>
            <a:ext cx="53572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sz="1600" dirty="0"/>
              <a:t>PB2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008DC7C4-C9E6-CAA4-0425-5E6B99ADD6D6}"/>
              </a:ext>
            </a:extLst>
          </p:cNvPr>
          <p:cNvSpPr txBox="1"/>
          <p:nvPr/>
        </p:nvSpPr>
        <p:spPr>
          <a:xfrm>
            <a:off x="7106384" y="2033688"/>
            <a:ext cx="4475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sz="1600" dirty="0"/>
              <a:t>NP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807EF34-7462-C754-8ABC-95A714701582}"/>
              </a:ext>
            </a:extLst>
          </p:cNvPr>
          <p:cNvSpPr txBox="1"/>
          <p:nvPr/>
        </p:nvSpPr>
        <p:spPr>
          <a:xfrm>
            <a:off x="7022785" y="3251632"/>
            <a:ext cx="6415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sz="1600" dirty="0"/>
              <a:t>Actin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D58AB06-96DF-1597-7196-715838F35807}"/>
              </a:ext>
            </a:extLst>
          </p:cNvPr>
          <p:cNvSpPr txBox="1"/>
          <p:nvPr/>
        </p:nvSpPr>
        <p:spPr>
          <a:xfrm>
            <a:off x="7104781" y="2641214"/>
            <a:ext cx="45076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sz="1600" dirty="0"/>
              <a:t>H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FB79DED-7964-988D-D084-8DFABE0BF822}"/>
              </a:ext>
            </a:extLst>
          </p:cNvPr>
          <p:cNvSpPr txBox="1"/>
          <p:nvPr/>
        </p:nvSpPr>
        <p:spPr>
          <a:xfrm>
            <a:off x="7104781" y="4113554"/>
            <a:ext cx="55335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sz="1600" dirty="0"/>
              <a:t>NS1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FECD9E7-5814-81F8-36A8-0BB958CDA952}"/>
              </a:ext>
            </a:extLst>
          </p:cNvPr>
          <p:cNvSpPr txBox="1"/>
          <p:nvPr/>
        </p:nvSpPr>
        <p:spPr>
          <a:xfrm>
            <a:off x="7140289" y="5310321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sz="1600" dirty="0"/>
              <a:t>M2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1C0374E3-771D-C634-41EA-040634180E9B}"/>
              </a:ext>
            </a:extLst>
          </p:cNvPr>
          <p:cNvSpPr txBox="1"/>
          <p:nvPr/>
        </p:nvSpPr>
        <p:spPr>
          <a:xfrm>
            <a:off x="7153672" y="4724434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sz="1600" dirty="0"/>
              <a:t>M1</a:t>
            </a:r>
          </a:p>
        </p:txBody>
      </p:sp>
      <p:pic>
        <p:nvPicPr>
          <p:cNvPr id="22" name="Picture 21">
            <a:extLst>
              <a:ext uri="{FF2B5EF4-FFF2-40B4-BE49-F238E27FC236}">
                <a16:creationId xmlns:a16="http://schemas.microsoft.com/office/drawing/2014/main" id="{BE99D69F-0011-266A-F6FB-38CDB32B521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829503" y="1328057"/>
            <a:ext cx="4106619" cy="45629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B08A101E-9B0B-54FE-0743-B1D05BED746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775182" y="3187217"/>
            <a:ext cx="4215260" cy="45629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C12D4C05-A683-F927-0C1A-7E23C2F1F96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775182" y="1947777"/>
            <a:ext cx="4215260" cy="45629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0BD8E734-B58C-46B3-EB42-877AAB6FB1AE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897388" y="5968052"/>
            <a:ext cx="4084886" cy="36937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2" name="Picture 31">
            <a:extLst>
              <a:ext uri="{FF2B5EF4-FFF2-40B4-BE49-F238E27FC236}">
                <a16:creationId xmlns:a16="http://schemas.microsoft.com/office/drawing/2014/main" id="{FF3A310A-120B-7DE5-7C63-8326322BE09E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897388" y="4709955"/>
            <a:ext cx="4084886" cy="36937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4" name="Picture 33">
            <a:extLst>
              <a:ext uri="{FF2B5EF4-FFF2-40B4-BE49-F238E27FC236}">
                <a16:creationId xmlns:a16="http://schemas.microsoft.com/office/drawing/2014/main" id="{24FCA302-0D18-1C38-2EDC-6AB52B77C663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897388" y="5339003"/>
            <a:ext cx="4084886" cy="36937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5" name="TextBox 34">
            <a:extLst>
              <a:ext uri="{FF2B5EF4-FFF2-40B4-BE49-F238E27FC236}">
                <a16:creationId xmlns:a16="http://schemas.microsoft.com/office/drawing/2014/main" id="{B4C4DC78-CB99-5522-3CE9-C7179A49D578}"/>
              </a:ext>
            </a:extLst>
          </p:cNvPr>
          <p:cNvSpPr txBox="1"/>
          <p:nvPr/>
        </p:nvSpPr>
        <p:spPr>
          <a:xfrm>
            <a:off x="7047315" y="5951795"/>
            <a:ext cx="6415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sz="1600" dirty="0"/>
              <a:t>Actin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E80F9976-51C9-9BEE-FF4A-B3B2BBD3B28C}"/>
              </a:ext>
            </a:extLst>
          </p:cNvPr>
          <p:cNvSpPr txBox="1"/>
          <p:nvPr/>
        </p:nvSpPr>
        <p:spPr>
          <a:xfrm>
            <a:off x="174172" y="6172810"/>
            <a:ext cx="212641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/>
              <a:t>M</a:t>
            </a:r>
            <a:r>
              <a:rPr lang="en-PT" sz="1600" dirty="0"/>
              <a:t>ocks on another gel.</a:t>
            </a:r>
          </a:p>
        </p:txBody>
      </p:sp>
      <p:pic>
        <p:nvPicPr>
          <p:cNvPr id="38" name="Picture 37">
            <a:extLst>
              <a:ext uri="{FF2B5EF4-FFF2-40B4-BE49-F238E27FC236}">
                <a16:creationId xmlns:a16="http://schemas.microsoft.com/office/drawing/2014/main" id="{279BD3B2-65F8-BB89-CBB2-414F9B1CEA72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914967" y="4100408"/>
            <a:ext cx="4067307" cy="34987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9" name="Left Bracket 38">
            <a:extLst>
              <a:ext uri="{FF2B5EF4-FFF2-40B4-BE49-F238E27FC236}">
                <a16:creationId xmlns:a16="http://schemas.microsoft.com/office/drawing/2014/main" id="{47E0E925-DE18-488D-045F-0B5DF847792F}"/>
              </a:ext>
            </a:extLst>
          </p:cNvPr>
          <p:cNvSpPr/>
          <p:nvPr/>
        </p:nvSpPr>
        <p:spPr>
          <a:xfrm rot="5400000">
            <a:off x="3472729" y="347896"/>
            <a:ext cx="65900" cy="1352354"/>
          </a:xfrm>
          <a:prstGeom prst="leftBracket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PT" dirty="0"/>
          </a:p>
        </p:txBody>
      </p:sp>
      <p:sp>
        <p:nvSpPr>
          <p:cNvPr id="42" name="Left Bracket 41">
            <a:extLst>
              <a:ext uri="{FF2B5EF4-FFF2-40B4-BE49-F238E27FC236}">
                <a16:creationId xmlns:a16="http://schemas.microsoft.com/office/drawing/2014/main" id="{4106CA4D-D081-1E15-5683-F0F50077BECB}"/>
              </a:ext>
            </a:extLst>
          </p:cNvPr>
          <p:cNvSpPr/>
          <p:nvPr/>
        </p:nvSpPr>
        <p:spPr>
          <a:xfrm rot="5400000">
            <a:off x="4835900" y="352493"/>
            <a:ext cx="75095" cy="1352354"/>
          </a:xfrm>
          <a:prstGeom prst="leftBracket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r>
              <a:rPr lang="en-PT" dirty="0"/>
              <a:t>        </a:t>
            </a:r>
          </a:p>
        </p:txBody>
      </p:sp>
      <p:sp>
        <p:nvSpPr>
          <p:cNvPr id="43" name="Left Bracket 42">
            <a:extLst>
              <a:ext uri="{FF2B5EF4-FFF2-40B4-BE49-F238E27FC236}">
                <a16:creationId xmlns:a16="http://schemas.microsoft.com/office/drawing/2014/main" id="{822B47B6-7DD5-D465-63F8-913C1A962257}"/>
              </a:ext>
            </a:extLst>
          </p:cNvPr>
          <p:cNvSpPr/>
          <p:nvPr/>
        </p:nvSpPr>
        <p:spPr>
          <a:xfrm rot="5400000">
            <a:off x="6209810" y="352493"/>
            <a:ext cx="75096" cy="1352354"/>
          </a:xfrm>
          <a:prstGeom prst="leftBracket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r>
              <a:rPr lang="en-PT" dirty="0"/>
              <a:t>   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98EDFA65-9DB5-5AF7-DFB9-011D5874B041}"/>
              </a:ext>
            </a:extLst>
          </p:cNvPr>
          <p:cNvSpPr txBox="1"/>
          <p:nvPr/>
        </p:nvSpPr>
        <p:spPr>
          <a:xfrm>
            <a:off x="2235169" y="1041762"/>
            <a:ext cx="4635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sz="1600" dirty="0"/>
              <a:t>hpi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AE9F330B-5821-DEEF-EE11-AB545C5B0A5A}"/>
              </a:ext>
            </a:extLst>
          </p:cNvPr>
          <p:cNvSpPr txBox="1"/>
          <p:nvPr/>
        </p:nvSpPr>
        <p:spPr>
          <a:xfrm>
            <a:off x="2854280" y="1028945"/>
            <a:ext cx="4299392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42900" indent="-342900">
              <a:buAutoNum type="arabicPlain" startAt="4"/>
            </a:pPr>
            <a:r>
              <a:rPr lang="en-PT" sz="1600" dirty="0"/>
              <a:t>8    12    16     4    8    12   16     4    8     12   16   	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4750794E-4B7A-23DA-C61D-4F8A7B16E711}"/>
              </a:ext>
            </a:extLst>
          </p:cNvPr>
          <p:cNvSpPr txBox="1"/>
          <p:nvPr/>
        </p:nvSpPr>
        <p:spPr>
          <a:xfrm>
            <a:off x="3216177" y="737435"/>
            <a:ext cx="5790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sz="1400" dirty="0"/>
              <a:t>A549</a:t>
            </a:r>
            <a:endParaRPr lang="en-PT" dirty="0"/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BF61D255-10D2-E721-CCF0-7763CB4160FD}"/>
              </a:ext>
            </a:extLst>
          </p:cNvPr>
          <p:cNvSpPr txBox="1"/>
          <p:nvPr/>
        </p:nvSpPr>
        <p:spPr>
          <a:xfrm>
            <a:off x="4216537" y="737435"/>
            <a:ext cx="13138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sz="1400" dirty="0"/>
              <a:t>GFP-Rab11WT</a:t>
            </a:r>
            <a:endParaRPr lang="en-PT" dirty="0"/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020DAC7F-05E6-4FA9-3A7A-F584680129A9}"/>
              </a:ext>
            </a:extLst>
          </p:cNvPr>
          <p:cNvSpPr txBox="1"/>
          <p:nvPr/>
        </p:nvSpPr>
        <p:spPr>
          <a:xfrm>
            <a:off x="5590191" y="737435"/>
            <a:ext cx="13143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sz="1400" dirty="0"/>
              <a:t>GFP-Rab11DN</a:t>
            </a:r>
            <a:endParaRPr lang="en-PT" dirty="0"/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4E1E8526-CE0E-C009-AC9A-E1878A9DE860}"/>
              </a:ext>
            </a:extLst>
          </p:cNvPr>
          <p:cNvSpPr txBox="1"/>
          <p:nvPr/>
        </p:nvSpPr>
        <p:spPr>
          <a:xfrm>
            <a:off x="124078" y="5523692"/>
            <a:ext cx="234288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/>
              <a:t>h</a:t>
            </a:r>
            <a:r>
              <a:rPr lang="en-PT" sz="1600" dirty="0"/>
              <a:t>pi- hours post infection</a:t>
            </a:r>
          </a:p>
        </p:txBody>
      </p:sp>
      <p:pic>
        <p:nvPicPr>
          <p:cNvPr id="52" name="Picture 51">
            <a:extLst>
              <a:ext uri="{FF2B5EF4-FFF2-40B4-BE49-F238E27FC236}">
                <a16:creationId xmlns:a16="http://schemas.microsoft.com/office/drawing/2014/main" id="{ADD96890-3FA3-3E8D-0FE2-31B453F6B341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775183" y="2542855"/>
            <a:ext cx="4215259" cy="535271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4075650053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1DCFB1-6333-46A6-9A39-6840273F05B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PT" dirty="0"/>
              <a:t>I</a:t>
            </a:r>
            <a:r>
              <a:rPr lang="en-GB" dirty="0"/>
              <a:t>n</a:t>
            </a:r>
            <a:r>
              <a:rPr lang="en-PT" dirty="0"/>
              <a:t>f and mocks – R3</a:t>
            </a:r>
          </a:p>
        </p:txBody>
      </p:sp>
      <p:pic>
        <p:nvPicPr>
          <p:cNvPr id="5" name="Content Placeholder 4" descr="A close-up of a test&#10;&#10;AI-generated content may be incorrect.">
            <a:extLst>
              <a:ext uri="{FF2B5EF4-FFF2-40B4-BE49-F238E27FC236}">
                <a16:creationId xmlns:a16="http://schemas.microsoft.com/office/drawing/2014/main" id="{B8D44E32-BA74-3E59-3851-10622A6A97C8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838200" y="2436002"/>
            <a:ext cx="10099565" cy="3604078"/>
          </a:xfr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00B8FBF3-1C05-2C38-D5E4-FFF15AAFD578}"/>
              </a:ext>
            </a:extLst>
          </p:cNvPr>
          <p:cNvSpPr txBox="1"/>
          <p:nvPr/>
        </p:nvSpPr>
        <p:spPr>
          <a:xfrm>
            <a:off x="60434" y="3657600"/>
            <a:ext cx="9149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100kd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6B4585D-C21D-2E1D-FAF4-3FE768058876}"/>
              </a:ext>
            </a:extLst>
          </p:cNvPr>
          <p:cNvSpPr txBox="1"/>
          <p:nvPr/>
        </p:nvSpPr>
        <p:spPr>
          <a:xfrm>
            <a:off x="122149" y="4026932"/>
            <a:ext cx="7914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75kd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EDF4CEF-CC48-94A9-4079-792687A875CA}"/>
              </a:ext>
            </a:extLst>
          </p:cNvPr>
          <p:cNvSpPr txBox="1"/>
          <p:nvPr/>
        </p:nvSpPr>
        <p:spPr>
          <a:xfrm>
            <a:off x="114530" y="5063864"/>
            <a:ext cx="7914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48kd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896AC53-5781-FF14-A6B8-C6E3B9A26B6C}"/>
              </a:ext>
            </a:extLst>
          </p:cNvPr>
          <p:cNvSpPr txBox="1"/>
          <p:nvPr/>
        </p:nvSpPr>
        <p:spPr>
          <a:xfrm>
            <a:off x="123694" y="4506541"/>
            <a:ext cx="7914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63kd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6EAA585-9F59-751C-20E1-2F241DD523C9}"/>
              </a:ext>
            </a:extLst>
          </p:cNvPr>
          <p:cNvSpPr txBox="1"/>
          <p:nvPr/>
        </p:nvSpPr>
        <p:spPr>
          <a:xfrm>
            <a:off x="122149" y="5624512"/>
            <a:ext cx="7914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35kd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D728B46-3446-3C8D-F97B-99338B7CFD6A}"/>
              </a:ext>
            </a:extLst>
          </p:cNvPr>
          <p:cNvSpPr txBox="1"/>
          <p:nvPr/>
        </p:nvSpPr>
        <p:spPr>
          <a:xfrm>
            <a:off x="1534510" y="6308209"/>
            <a:ext cx="23803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PB2, HA, NP and actin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76EA6F55-4C70-E598-FB7B-0C284ADE83F5}"/>
              </a:ext>
            </a:extLst>
          </p:cNvPr>
          <p:cNvSpPr txBox="1"/>
          <p:nvPr/>
        </p:nvSpPr>
        <p:spPr>
          <a:xfrm>
            <a:off x="5331030" y="3939049"/>
            <a:ext cx="5806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PB2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811E4456-401B-BC37-02E5-790B66D5E59B}"/>
              </a:ext>
            </a:extLst>
          </p:cNvPr>
          <p:cNvSpPr txBox="1"/>
          <p:nvPr/>
        </p:nvSpPr>
        <p:spPr>
          <a:xfrm>
            <a:off x="5307374" y="4272748"/>
            <a:ext cx="4844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HA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CC84B5C8-BB39-82B6-F44C-17FD6F37D8D6}"/>
              </a:ext>
            </a:extLst>
          </p:cNvPr>
          <p:cNvSpPr txBox="1"/>
          <p:nvPr/>
        </p:nvSpPr>
        <p:spPr>
          <a:xfrm>
            <a:off x="5331030" y="4670269"/>
            <a:ext cx="4812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NP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5855C90-699F-47B5-3E62-B128CC4F15AC}"/>
              </a:ext>
            </a:extLst>
          </p:cNvPr>
          <p:cNvSpPr txBox="1"/>
          <p:nvPr/>
        </p:nvSpPr>
        <p:spPr>
          <a:xfrm>
            <a:off x="5343196" y="5156414"/>
            <a:ext cx="6864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actin</a:t>
            </a:r>
          </a:p>
        </p:txBody>
      </p:sp>
    </p:spTree>
    <p:extLst>
      <p:ext uri="{BB962C8B-B14F-4D97-AF65-F5344CB8AC3E}">
        <p14:creationId xmlns:p14="http://schemas.microsoft.com/office/powerpoint/2010/main" val="2374654100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CE5826D-B7F7-BFB3-8400-C672CC9AADE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6D99AB-D150-DCC3-B3CF-AC4D320640C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PT" dirty="0"/>
              <a:t>I</a:t>
            </a:r>
            <a:r>
              <a:rPr lang="en-GB" dirty="0"/>
              <a:t>n</a:t>
            </a:r>
            <a:r>
              <a:rPr lang="en-PT" dirty="0"/>
              <a:t>f and mocks – R3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30D2CAA-2F83-B0C4-7193-2AE3EE15D5FA}"/>
              </a:ext>
            </a:extLst>
          </p:cNvPr>
          <p:cNvSpPr txBox="1"/>
          <p:nvPr/>
        </p:nvSpPr>
        <p:spPr>
          <a:xfrm>
            <a:off x="324737" y="3429000"/>
            <a:ext cx="7914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48kd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E5CFAF5-A935-58F8-5F78-1BED2C251CE8}"/>
              </a:ext>
            </a:extLst>
          </p:cNvPr>
          <p:cNvSpPr txBox="1"/>
          <p:nvPr/>
        </p:nvSpPr>
        <p:spPr>
          <a:xfrm>
            <a:off x="324736" y="3795655"/>
            <a:ext cx="7914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35kd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D3B869D-1DB6-7D34-8CC4-61A87F802749}"/>
              </a:ext>
            </a:extLst>
          </p:cNvPr>
          <p:cNvSpPr txBox="1"/>
          <p:nvPr/>
        </p:nvSpPr>
        <p:spPr>
          <a:xfrm>
            <a:off x="1534510" y="6308209"/>
            <a:ext cx="24128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NS1, M1, M2 and actin</a:t>
            </a:r>
          </a:p>
        </p:txBody>
      </p:sp>
      <p:pic>
        <p:nvPicPr>
          <p:cNvPr id="13" name="Content Placeholder 12" descr="A close-up of a test&#10;&#10;AI-generated content may be incorrect.">
            <a:extLst>
              <a:ext uri="{FF2B5EF4-FFF2-40B4-BE49-F238E27FC236}">
                <a16:creationId xmlns:a16="http://schemas.microsoft.com/office/drawing/2014/main" id="{7FD43708-20D2-E487-2CC4-75E4F0B8D125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1037079" y="2191689"/>
            <a:ext cx="10515600" cy="3752543"/>
          </a:xfr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77CF94B6-59C9-A005-3D61-93B87542D8FE}"/>
              </a:ext>
            </a:extLst>
          </p:cNvPr>
          <p:cNvSpPr txBox="1"/>
          <p:nvPr/>
        </p:nvSpPr>
        <p:spPr>
          <a:xfrm>
            <a:off x="442450" y="4318622"/>
            <a:ext cx="7914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25kda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FEBB504E-8E61-C0FD-2E58-8047AEC01536}"/>
              </a:ext>
            </a:extLst>
          </p:cNvPr>
          <p:cNvSpPr txBox="1"/>
          <p:nvPr/>
        </p:nvSpPr>
        <p:spPr>
          <a:xfrm>
            <a:off x="442450" y="4656923"/>
            <a:ext cx="7914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20kda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8E14FA6C-1D9A-C9F3-E3BE-DDCC66CDBF07}"/>
              </a:ext>
            </a:extLst>
          </p:cNvPr>
          <p:cNvSpPr txBox="1"/>
          <p:nvPr/>
        </p:nvSpPr>
        <p:spPr>
          <a:xfrm>
            <a:off x="442449" y="5035643"/>
            <a:ext cx="7914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17kda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37A39428-BD37-99FE-DC8F-28136712B3B7}"/>
              </a:ext>
            </a:extLst>
          </p:cNvPr>
          <p:cNvSpPr txBox="1"/>
          <p:nvPr/>
        </p:nvSpPr>
        <p:spPr>
          <a:xfrm>
            <a:off x="499238" y="5453783"/>
            <a:ext cx="7914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11kda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914C59E3-4D90-8D95-0B8E-696B94794864}"/>
              </a:ext>
            </a:extLst>
          </p:cNvPr>
          <p:cNvSpPr txBox="1"/>
          <p:nvPr/>
        </p:nvSpPr>
        <p:spPr>
          <a:xfrm>
            <a:off x="6294879" y="6260567"/>
            <a:ext cx="27632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b="1" u="sng" dirty="0"/>
              <a:t>M1 and NS1 overlap here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39666CBD-8C8B-EE29-CF39-7D372A1FE663}"/>
              </a:ext>
            </a:extLst>
          </p:cNvPr>
          <p:cNvSpPr txBox="1"/>
          <p:nvPr/>
        </p:nvSpPr>
        <p:spPr>
          <a:xfrm>
            <a:off x="5752797" y="3426323"/>
            <a:ext cx="6864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actin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61E312AE-0744-43B7-7448-561F72482531}"/>
              </a:ext>
            </a:extLst>
          </p:cNvPr>
          <p:cNvSpPr txBox="1"/>
          <p:nvPr/>
        </p:nvSpPr>
        <p:spPr>
          <a:xfrm>
            <a:off x="5585347" y="4067960"/>
            <a:ext cx="13805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NS1 and M1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01C9C993-A31A-DD5F-1FAD-4618681214E6}"/>
              </a:ext>
            </a:extLst>
          </p:cNvPr>
          <p:cNvSpPr txBox="1"/>
          <p:nvPr/>
        </p:nvSpPr>
        <p:spPr>
          <a:xfrm>
            <a:off x="5804039" y="5084451"/>
            <a:ext cx="4908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M2</a:t>
            </a:r>
          </a:p>
        </p:txBody>
      </p:sp>
    </p:spTree>
    <p:extLst>
      <p:ext uri="{BB962C8B-B14F-4D97-AF65-F5344CB8AC3E}">
        <p14:creationId xmlns:p14="http://schemas.microsoft.com/office/powerpoint/2010/main" val="84178310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4814E78-1BD3-9A86-DB85-0ED99F02C60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PT" dirty="0"/>
              <a:t>M1 on left, NS1 on right – separated channels</a:t>
            </a:r>
          </a:p>
        </p:txBody>
      </p:sp>
      <p:pic>
        <p:nvPicPr>
          <p:cNvPr id="5" name="Content Placeholder 4" descr="A close-up of a test&#10;&#10;AI-generated content may be incorrect.">
            <a:extLst>
              <a:ext uri="{FF2B5EF4-FFF2-40B4-BE49-F238E27FC236}">
                <a16:creationId xmlns:a16="http://schemas.microsoft.com/office/drawing/2014/main" id="{850F3196-8B93-F628-D30C-3D6C162CAFBE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rcRect r="48734"/>
          <a:stretch>
            <a:fillRect/>
          </a:stretch>
        </p:blipFill>
        <p:spPr>
          <a:xfrm>
            <a:off x="6096000" y="2038277"/>
            <a:ext cx="6005165" cy="4180144"/>
          </a:xfrm>
        </p:spPr>
      </p:pic>
      <p:pic>
        <p:nvPicPr>
          <p:cNvPr id="7" name="Picture 6" descr="A close-up of a paper&#10;&#10;AI-generated content may be incorrect.">
            <a:extLst>
              <a:ext uri="{FF2B5EF4-FFF2-40B4-BE49-F238E27FC236}">
                <a16:creationId xmlns:a16="http://schemas.microsoft.com/office/drawing/2014/main" id="{E1D73664-5C85-1187-8C4E-B139EDF3A9BD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r="48802"/>
          <a:stretch>
            <a:fillRect/>
          </a:stretch>
        </p:blipFill>
        <p:spPr>
          <a:xfrm>
            <a:off x="0" y="2067553"/>
            <a:ext cx="6096000" cy="424896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30030818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01C6ED8-0EFD-8B44-AE18-98C54AC56BF9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PT" dirty="0"/>
              <a:t>MDCK-HA WBs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9AC12F1-6ED5-9F24-3670-8F5AFEF0B75A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PT"/>
          </a:p>
        </p:txBody>
      </p:sp>
    </p:spTree>
    <p:extLst>
      <p:ext uri="{BB962C8B-B14F-4D97-AF65-F5344CB8AC3E}">
        <p14:creationId xmlns:p14="http://schemas.microsoft.com/office/powerpoint/2010/main" val="3896353271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>
            <a:extLst>
              <a:ext uri="{FF2B5EF4-FFF2-40B4-BE49-F238E27FC236}">
                <a16:creationId xmlns:a16="http://schemas.microsoft.com/office/drawing/2014/main" id="{1FE1E0E2-18AB-50D4-5F05-D8D09FDB6EAD}"/>
              </a:ext>
            </a:extLst>
          </p:cNvPr>
          <p:cNvSpPr txBox="1">
            <a:spLocks/>
          </p:cNvSpPr>
          <p:nvPr/>
        </p:nvSpPr>
        <p:spPr>
          <a:xfrm>
            <a:off x="290304" y="22847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PT" sz="3600" dirty="0"/>
              <a:t>WB virions EXP1 – 16hpi</a:t>
            </a:r>
          </a:p>
        </p:txBody>
      </p:sp>
      <p:pic>
        <p:nvPicPr>
          <p:cNvPr id="8" name="Picture 7" descr="A close-up of a dna&#10;&#10;AI-generated content may be incorrect.">
            <a:extLst>
              <a:ext uri="{FF2B5EF4-FFF2-40B4-BE49-F238E27FC236}">
                <a16:creationId xmlns:a16="http://schemas.microsoft.com/office/drawing/2014/main" id="{B7503B89-A8F1-919C-E549-3C881018333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95341" y="1295860"/>
            <a:ext cx="6676883" cy="5452789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231232DD-3FE6-CFD7-DBE4-EF0F0F253704}"/>
              </a:ext>
            </a:extLst>
          </p:cNvPr>
          <p:cNvSpPr txBox="1"/>
          <p:nvPr/>
        </p:nvSpPr>
        <p:spPr>
          <a:xfrm>
            <a:off x="3200595" y="1467937"/>
            <a:ext cx="6383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PT" sz="1200" dirty="0"/>
              <a:t>MDCK 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E71F3E9-1E3B-7539-5C2E-F55D321A1799}"/>
              </a:ext>
            </a:extLst>
          </p:cNvPr>
          <p:cNvSpPr txBox="1"/>
          <p:nvPr/>
        </p:nvSpPr>
        <p:spPr>
          <a:xfrm>
            <a:off x="3822675" y="1467937"/>
            <a:ext cx="4789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PT" sz="1200" dirty="0"/>
              <a:t>-HA </a:t>
            </a:r>
          </a:p>
        </p:txBody>
      </p:sp>
      <p:sp>
        <p:nvSpPr>
          <p:cNvPr id="11" name="Left Brace 10">
            <a:extLst>
              <a:ext uri="{FF2B5EF4-FFF2-40B4-BE49-F238E27FC236}">
                <a16:creationId xmlns:a16="http://schemas.microsoft.com/office/drawing/2014/main" id="{5DF5B5D5-AFD3-E882-D756-AAF70FC7A3E0}"/>
              </a:ext>
            </a:extLst>
          </p:cNvPr>
          <p:cNvSpPr/>
          <p:nvPr/>
        </p:nvSpPr>
        <p:spPr>
          <a:xfrm rot="5400000">
            <a:off x="3613577" y="884842"/>
            <a:ext cx="277000" cy="1099037"/>
          </a:xfrm>
          <a:prstGeom prst="leftBrace">
            <a:avLst>
              <a:gd name="adj1" fmla="val 19715"/>
              <a:gd name="adj2" fmla="val 50000"/>
            </a:avLst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PT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5C1F60A-059B-0BB9-F245-AC8120B8DD7C}"/>
              </a:ext>
            </a:extLst>
          </p:cNvPr>
          <p:cNvSpPr txBox="1"/>
          <p:nvPr/>
        </p:nvSpPr>
        <p:spPr>
          <a:xfrm>
            <a:off x="3402623" y="979078"/>
            <a:ext cx="6826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WSN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BB216DD5-2B3F-1026-13A5-086F92EC4B6D}"/>
              </a:ext>
            </a:extLst>
          </p:cNvPr>
          <p:cNvSpPr txBox="1"/>
          <p:nvPr/>
        </p:nvSpPr>
        <p:spPr>
          <a:xfrm>
            <a:off x="4299633" y="1467937"/>
            <a:ext cx="6383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PT" sz="1200" dirty="0"/>
              <a:t>MDCK 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0FDF7B25-01F8-2C1C-E832-280B4BE3C4A9}"/>
              </a:ext>
            </a:extLst>
          </p:cNvPr>
          <p:cNvSpPr txBox="1"/>
          <p:nvPr/>
        </p:nvSpPr>
        <p:spPr>
          <a:xfrm>
            <a:off x="4921713" y="1467937"/>
            <a:ext cx="4789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PT" sz="1200" dirty="0"/>
              <a:t>-HA </a:t>
            </a:r>
          </a:p>
        </p:txBody>
      </p:sp>
      <p:sp>
        <p:nvSpPr>
          <p:cNvPr id="15" name="Left Brace 14">
            <a:extLst>
              <a:ext uri="{FF2B5EF4-FFF2-40B4-BE49-F238E27FC236}">
                <a16:creationId xmlns:a16="http://schemas.microsoft.com/office/drawing/2014/main" id="{198DDC25-EEB8-D97A-3389-0BE4F0270C9B}"/>
              </a:ext>
            </a:extLst>
          </p:cNvPr>
          <p:cNvSpPr/>
          <p:nvPr/>
        </p:nvSpPr>
        <p:spPr>
          <a:xfrm rot="5400000">
            <a:off x="4712615" y="884842"/>
            <a:ext cx="277000" cy="1099037"/>
          </a:xfrm>
          <a:prstGeom prst="leftBrace">
            <a:avLst>
              <a:gd name="adj1" fmla="val 19715"/>
              <a:gd name="adj2" fmla="val 50000"/>
            </a:avLst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PT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0684C7A4-8EB4-2E95-7809-676D518DC01E}"/>
              </a:ext>
            </a:extLst>
          </p:cNvPr>
          <p:cNvSpPr txBox="1"/>
          <p:nvPr/>
        </p:nvSpPr>
        <p:spPr>
          <a:xfrm>
            <a:off x="4321385" y="979078"/>
            <a:ext cx="9932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deltaHA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F51D8F5D-2B2A-BBB1-3983-3B8B4D3532AA}"/>
              </a:ext>
            </a:extLst>
          </p:cNvPr>
          <p:cNvSpPr txBox="1"/>
          <p:nvPr/>
        </p:nvSpPr>
        <p:spPr>
          <a:xfrm>
            <a:off x="5398671" y="1467937"/>
            <a:ext cx="6383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PT" sz="1200" dirty="0"/>
              <a:t>MDCK 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D441B4FC-1064-7E47-36F2-9A48DA900EB3}"/>
              </a:ext>
            </a:extLst>
          </p:cNvPr>
          <p:cNvSpPr txBox="1"/>
          <p:nvPr/>
        </p:nvSpPr>
        <p:spPr>
          <a:xfrm>
            <a:off x="6020751" y="1467937"/>
            <a:ext cx="4789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PT" sz="1200" dirty="0"/>
              <a:t>-HA </a:t>
            </a:r>
          </a:p>
        </p:txBody>
      </p:sp>
      <p:sp>
        <p:nvSpPr>
          <p:cNvPr id="19" name="Left Brace 18">
            <a:extLst>
              <a:ext uri="{FF2B5EF4-FFF2-40B4-BE49-F238E27FC236}">
                <a16:creationId xmlns:a16="http://schemas.microsoft.com/office/drawing/2014/main" id="{70143E86-3C50-A82A-1180-2DB2BD563AFC}"/>
              </a:ext>
            </a:extLst>
          </p:cNvPr>
          <p:cNvSpPr/>
          <p:nvPr/>
        </p:nvSpPr>
        <p:spPr>
          <a:xfrm rot="5400000">
            <a:off x="5811653" y="884842"/>
            <a:ext cx="277000" cy="1099037"/>
          </a:xfrm>
          <a:prstGeom prst="leftBrace">
            <a:avLst>
              <a:gd name="adj1" fmla="val 19715"/>
              <a:gd name="adj2" fmla="val 50000"/>
            </a:avLst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PT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5529EE78-F70A-3F2B-F750-350436B8F03D}"/>
              </a:ext>
            </a:extLst>
          </p:cNvPr>
          <p:cNvSpPr txBox="1"/>
          <p:nvPr/>
        </p:nvSpPr>
        <p:spPr>
          <a:xfrm>
            <a:off x="5600699" y="979078"/>
            <a:ext cx="7280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Mock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E0EBECB7-30CD-38BE-A972-2898F832219B}"/>
              </a:ext>
            </a:extLst>
          </p:cNvPr>
          <p:cNvSpPr txBox="1"/>
          <p:nvPr/>
        </p:nvSpPr>
        <p:spPr>
          <a:xfrm>
            <a:off x="6510780" y="756509"/>
            <a:ext cx="817853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Mock</a:t>
            </a:r>
          </a:p>
          <a:p>
            <a:r>
              <a:rPr lang="en-PT" dirty="0"/>
              <a:t>MDCK</a:t>
            </a:r>
          </a:p>
          <a:p>
            <a:r>
              <a:rPr lang="en-PT" dirty="0"/>
              <a:t>cells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DC693DAC-2AE8-EFF1-884F-881B8B311E45}"/>
              </a:ext>
            </a:extLst>
          </p:cNvPr>
          <p:cNvSpPr txBox="1"/>
          <p:nvPr/>
        </p:nvSpPr>
        <p:spPr>
          <a:xfrm>
            <a:off x="7167374" y="756509"/>
            <a:ext cx="949299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16h INF</a:t>
            </a:r>
          </a:p>
          <a:p>
            <a:r>
              <a:rPr lang="en-PT" dirty="0"/>
              <a:t>MDCK</a:t>
            </a:r>
          </a:p>
          <a:p>
            <a:r>
              <a:rPr lang="en-PT" dirty="0"/>
              <a:t>cells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AE45FD67-0375-9502-4977-20CD0069F7A8}"/>
              </a:ext>
            </a:extLst>
          </p:cNvPr>
          <p:cNvSpPr txBox="1"/>
          <p:nvPr/>
        </p:nvSpPr>
        <p:spPr>
          <a:xfrm>
            <a:off x="1167619" y="3837588"/>
            <a:ext cx="8379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25 kda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5FDE74F8-2C19-E78F-246D-74C1AED40967}"/>
              </a:ext>
            </a:extLst>
          </p:cNvPr>
          <p:cNvSpPr txBox="1"/>
          <p:nvPr/>
        </p:nvSpPr>
        <p:spPr>
          <a:xfrm>
            <a:off x="1167619" y="4339036"/>
            <a:ext cx="8379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20 kda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B762E39D-5D20-46D9-27E1-2FD516D08B92}"/>
              </a:ext>
            </a:extLst>
          </p:cNvPr>
          <p:cNvSpPr txBox="1"/>
          <p:nvPr/>
        </p:nvSpPr>
        <p:spPr>
          <a:xfrm>
            <a:off x="1109004" y="4927535"/>
            <a:ext cx="8379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17 kda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FBA0D782-3115-230E-5DDE-5B5150F813DC}"/>
              </a:ext>
            </a:extLst>
          </p:cNvPr>
          <p:cNvSpPr txBox="1"/>
          <p:nvPr/>
        </p:nvSpPr>
        <p:spPr>
          <a:xfrm>
            <a:off x="1135653" y="5836218"/>
            <a:ext cx="8379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11 kda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B2BF0EB0-6147-5EEA-C768-9CF8FF832702}"/>
              </a:ext>
            </a:extLst>
          </p:cNvPr>
          <p:cNvSpPr txBox="1"/>
          <p:nvPr/>
        </p:nvSpPr>
        <p:spPr>
          <a:xfrm>
            <a:off x="8326804" y="3837588"/>
            <a:ext cx="4908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M1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D3A711E5-6AA7-9918-9719-950A80AF7ACA}"/>
              </a:ext>
            </a:extLst>
          </p:cNvPr>
          <p:cNvSpPr txBox="1"/>
          <p:nvPr/>
        </p:nvSpPr>
        <p:spPr>
          <a:xfrm>
            <a:off x="8229021" y="2583974"/>
            <a:ext cx="6864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actin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DEC7AE91-58D2-518F-AA5E-55B6CC8946D2}"/>
              </a:ext>
            </a:extLst>
          </p:cNvPr>
          <p:cNvSpPr txBox="1"/>
          <p:nvPr/>
        </p:nvSpPr>
        <p:spPr>
          <a:xfrm>
            <a:off x="8262604" y="2129633"/>
            <a:ext cx="4812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NP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8AC0F379-DA18-9481-132F-FEF968107FF5}"/>
              </a:ext>
            </a:extLst>
          </p:cNvPr>
          <p:cNvSpPr txBox="1"/>
          <p:nvPr/>
        </p:nvSpPr>
        <p:spPr>
          <a:xfrm>
            <a:off x="1155369" y="3071581"/>
            <a:ext cx="8379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35 kda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A0198D39-DE16-2B16-32E6-ECCE4DF19111}"/>
              </a:ext>
            </a:extLst>
          </p:cNvPr>
          <p:cNvSpPr txBox="1"/>
          <p:nvPr/>
        </p:nvSpPr>
        <p:spPr>
          <a:xfrm>
            <a:off x="1096504" y="2408000"/>
            <a:ext cx="8379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48 kda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32187128-1FE4-38DF-E429-033FC3E77E97}"/>
              </a:ext>
            </a:extLst>
          </p:cNvPr>
          <p:cNvSpPr txBox="1"/>
          <p:nvPr/>
        </p:nvSpPr>
        <p:spPr>
          <a:xfrm>
            <a:off x="1109004" y="1929085"/>
            <a:ext cx="8379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63 kda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FF8161C9-71A1-AF41-EBBD-3E8B02828F84}"/>
              </a:ext>
            </a:extLst>
          </p:cNvPr>
          <p:cNvSpPr txBox="1"/>
          <p:nvPr/>
        </p:nvSpPr>
        <p:spPr>
          <a:xfrm>
            <a:off x="1109612" y="1522320"/>
            <a:ext cx="8379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75 kda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DC4CB826-7BDB-2E87-CB32-A23AE049EE3C}"/>
              </a:ext>
            </a:extLst>
          </p:cNvPr>
          <p:cNvSpPr txBox="1"/>
          <p:nvPr/>
        </p:nvSpPr>
        <p:spPr>
          <a:xfrm>
            <a:off x="1080869" y="1310758"/>
            <a:ext cx="9614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100 kda</a:t>
            </a:r>
          </a:p>
        </p:txBody>
      </p:sp>
    </p:spTree>
    <p:extLst>
      <p:ext uri="{BB962C8B-B14F-4D97-AF65-F5344CB8AC3E}">
        <p14:creationId xmlns:p14="http://schemas.microsoft.com/office/powerpoint/2010/main" val="1088220595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close-up of a dna test&#10;&#10;AI-generated content may be incorrect.">
            <a:extLst>
              <a:ext uri="{FF2B5EF4-FFF2-40B4-BE49-F238E27FC236}">
                <a16:creationId xmlns:a16="http://schemas.microsoft.com/office/drawing/2014/main" id="{811B26D2-8DA8-B695-A6F6-4217D934781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52265" y="1217264"/>
            <a:ext cx="5428699" cy="4784617"/>
          </a:xfrm>
          <a:prstGeom prst="rect">
            <a:avLst/>
          </a:prstGeom>
        </p:spPr>
      </p:pic>
      <p:pic>
        <p:nvPicPr>
          <p:cNvPr id="5" name="Picture 4" descr="A close-up of a dna&#10;&#10;AI-generated content may be incorrect.">
            <a:extLst>
              <a:ext uri="{FF2B5EF4-FFF2-40B4-BE49-F238E27FC236}">
                <a16:creationId xmlns:a16="http://schemas.microsoft.com/office/drawing/2014/main" id="{9986DEE8-DDF4-F037-F940-7AB14C5D7CD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39797" y="1019148"/>
            <a:ext cx="5286224" cy="5180851"/>
          </a:xfrm>
          <a:prstGeom prst="rect">
            <a:avLst/>
          </a:prstGeom>
        </p:spPr>
      </p:pic>
      <p:sp>
        <p:nvSpPr>
          <p:cNvPr id="6" name="Title 1">
            <a:extLst>
              <a:ext uri="{FF2B5EF4-FFF2-40B4-BE49-F238E27FC236}">
                <a16:creationId xmlns:a16="http://schemas.microsoft.com/office/drawing/2014/main" id="{CD533A0F-17AA-B0BF-ECCE-4BB187B86991}"/>
              </a:ext>
            </a:extLst>
          </p:cNvPr>
          <p:cNvSpPr txBox="1">
            <a:spLocks/>
          </p:cNvSpPr>
          <p:nvPr/>
        </p:nvSpPr>
        <p:spPr>
          <a:xfrm>
            <a:off x="290304" y="22847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PT" sz="3600" dirty="0"/>
              <a:t>WB virions EXP2 and 3 – 16hpi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5F18F84-0D96-B5E6-333B-EB7F25A91737}"/>
              </a:ext>
            </a:extLst>
          </p:cNvPr>
          <p:cNvSpPr txBox="1"/>
          <p:nvPr/>
        </p:nvSpPr>
        <p:spPr>
          <a:xfrm>
            <a:off x="1824000" y="1942659"/>
            <a:ext cx="6383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PT" sz="1200" dirty="0"/>
              <a:t>MDCK 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1851EBE5-2E22-5CD6-2CEA-1DBFC0B196F6}"/>
              </a:ext>
            </a:extLst>
          </p:cNvPr>
          <p:cNvSpPr txBox="1"/>
          <p:nvPr/>
        </p:nvSpPr>
        <p:spPr>
          <a:xfrm>
            <a:off x="2446080" y="1942659"/>
            <a:ext cx="4789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PT" sz="1200" dirty="0"/>
              <a:t>-HA </a:t>
            </a:r>
          </a:p>
        </p:txBody>
      </p:sp>
      <p:sp>
        <p:nvSpPr>
          <p:cNvPr id="9" name="Left Brace 8">
            <a:extLst>
              <a:ext uri="{FF2B5EF4-FFF2-40B4-BE49-F238E27FC236}">
                <a16:creationId xmlns:a16="http://schemas.microsoft.com/office/drawing/2014/main" id="{04CF7050-135B-8FF1-25FD-3D6F7C05E822}"/>
              </a:ext>
            </a:extLst>
          </p:cNvPr>
          <p:cNvSpPr/>
          <p:nvPr/>
        </p:nvSpPr>
        <p:spPr>
          <a:xfrm rot="5400000">
            <a:off x="2236982" y="1359564"/>
            <a:ext cx="277000" cy="1099037"/>
          </a:xfrm>
          <a:prstGeom prst="leftBrace">
            <a:avLst>
              <a:gd name="adj1" fmla="val 19715"/>
              <a:gd name="adj2" fmla="val 50000"/>
            </a:avLst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PT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A29AB8C-4951-9871-1C01-6A98126F9211}"/>
              </a:ext>
            </a:extLst>
          </p:cNvPr>
          <p:cNvSpPr txBox="1"/>
          <p:nvPr/>
        </p:nvSpPr>
        <p:spPr>
          <a:xfrm>
            <a:off x="2026028" y="1453800"/>
            <a:ext cx="6826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WSN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EEB0F01-9D81-3825-560F-81D6D14412F1}"/>
              </a:ext>
            </a:extLst>
          </p:cNvPr>
          <p:cNvSpPr txBox="1"/>
          <p:nvPr/>
        </p:nvSpPr>
        <p:spPr>
          <a:xfrm>
            <a:off x="2923038" y="1942659"/>
            <a:ext cx="6383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PT" sz="1200" dirty="0"/>
              <a:t>MDCK 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E5349F36-54D6-37CD-8F3B-709C7D6DB4DE}"/>
              </a:ext>
            </a:extLst>
          </p:cNvPr>
          <p:cNvSpPr txBox="1"/>
          <p:nvPr/>
        </p:nvSpPr>
        <p:spPr>
          <a:xfrm>
            <a:off x="3545118" y="1942659"/>
            <a:ext cx="4789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PT" sz="1200" dirty="0"/>
              <a:t>-HA </a:t>
            </a:r>
          </a:p>
        </p:txBody>
      </p:sp>
      <p:sp>
        <p:nvSpPr>
          <p:cNvPr id="13" name="Left Brace 12">
            <a:extLst>
              <a:ext uri="{FF2B5EF4-FFF2-40B4-BE49-F238E27FC236}">
                <a16:creationId xmlns:a16="http://schemas.microsoft.com/office/drawing/2014/main" id="{B4F47825-6286-A5D9-E9CC-29652B79F1E5}"/>
              </a:ext>
            </a:extLst>
          </p:cNvPr>
          <p:cNvSpPr/>
          <p:nvPr/>
        </p:nvSpPr>
        <p:spPr>
          <a:xfrm rot="5400000">
            <a:off x="3336020" y="1359564"/>
            <a:ext cx="277000" cy="1099037"/>
          </a:xfrm>
          <a:prstGeom prst="leftBrace">
            <a:avLst>
              <a:gd name="adj1" fmla="val 19715"/>
              <a:gd name="adj2" fmla="val 50000"/>
            </a:avLst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PT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A9ABF1B7-999D-6514-1993-F011288ECB68}"/>
              </a:ext>
            </a:extLst>
          </p:cNvPr>
          <p:cNvSpPr txBox="1"/>
          <p:nvPr/>
        </p:nvSpPr>
        <p:spPr>
          <a:xfrm>
            <a:off x="2944790" y="1453800"/>
            <a:ext cx="9932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deltaHA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CA7396CA-369C-96FC-CB66-5F0476AE5227}"/>
              </a:ext>
            </a:extLst>
          </p:cNvPr>
          <p:cNvSpPr txBox="1"/>
          <p:nvPr/>
        </p:nvSpPr>
        <p:spPr>
          <a:xfrm>
            <a:off x="4022076" y="1942659"/>
            <a:ext cx="6383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PT" sz="1200" dirty="0"/>
              <a:t>MDCK 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AB2B0950-FFE5-510A-0B13-7716C3B51510}"/>
              </a:ext>
            </a:extLst>
          </p:cNvPr>
          <p:cNvSpPr txBox="1"/>
          <p:nvPr/>
        </p:nvSpPr>
        <p:spPr>
          <a:xfrm>
            <a:off x="4644156" y="1942659"/>
            <a:ext cx="4789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PT" sz="1200" dirty="0"/>
              <a:t>-HA </a:t>
            </a:r>
          </a:p>
        </p:txBody>
      </p:sp>
      <p:sp>
        <p:nvSpPr>
          <p:cNvPr id="17" name="Left Brace 16">
            <a:extLst>
              <a:ext uri="{FF2B5EF4-FFF2-40B4-BE49-F238E27FC236}">
                <a16:creationId xmlns:a16="http://schemas.microsoft.com/office/drawing/2014/main" id="{6AC4798C-3029-C40B-ECE5-EF3CFF7DC847}"/>
              </a:ext>
            </a:extLst>
          </p:cNvPr>
          <p:cNvSpPr/>
          <p:nvPr/>
        </p:nvSpPr>
        <p:spPr>
          <a:xfrm rot="5400000">
            <a:off x="4435058" y="1359564"/>
            <a:ext cx="277000" cy="1099037"/>
          </a:xfrm>
          <a:prstGeom prst="leftBrace">
            <a:avLst>
              <a:gd name="adj1" fmla="val 19715"/>
              <a:gd name="adj2" fmla="val 50000"/>
            </a:avLst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PT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BCA1BFFF-9947-7260-E02D-AC4252C46023}"/>
              </a:ext>
            </a:extLst>
          </p:cNvPr>
          <p:cNvSpPr txBox="1"/>
          <p:nvPr/>
        </p:nvSpPr>
        <p:spPr>
          <a:xfrm>
            <a:off x="4224104" y="1453800"/>
            <a:ext cx="7280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Mock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9169F07E-ACDF-D931-5DC2-45E5ADAB1FB2}"/>
              </a:ext>
            </a:extLst>
          </p:cNvPr>
          <p:cNvSpPr txBox="1"/>
          <p:nvPr/>
        </p:nvSpPr>
        <p:spPr>
          <a:xfrm>
            <a:off x="7345816" y="1959160"/>
            <a:ext cx="6383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PT" sz="1200" dirty="0"/>
              <a:t>MDCK 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CDF0F25C-201F-D3F7-C821-2E7DE5C1E6B7}"/>
              </a:ext>
            </a:extLst>
          </p:cNvPr>
          <p:cNvSpPr txBox="1"/>
          <p:nvPr/>
        </p:nvSpPr>
        <p:spPr>
          <a:xfrm>
            <a:off x="7967896" y="1959160"/>
            <a:ext cx="4789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PT" sz="1200" dirty="0"/>
              <a:t>-HA </a:t>
            </a:r>
          </a:p>
        </p:txBody>
      </p:sp>
      <p:sp>
        <p:nvSpPr>
          <p:cNvPr id="21" name="Left Brace 20">
            <a:extLst>
              <a:ext uri="{FF2B5EF4-FFF2-40B4-BE49-F238E27FC236}">
                <a16:creationId xmlns:a16="http://schemas.microsoft.com/office/drawing/2014/main" id="{F840B5D6-6668-67A0-7A70-228CE371D648}"/>
              </a:ext>
            </a:extLst>
          </p:cNvPr>
          <p:cNvSpPr/>
          <p:nvPr/>
        </p:nvSpPr>
        <p:spPr>
          <a:xfrm rot="5400000">
            <a:off x="7758798" y="1376065"/>
            <a:ext cx="277000" cy="1099037"/>
          </a:xfrm>
          <a:prstGeom prst="leftBrace">
            <a:avLst>
              <a:gd name="adj1" fmla="val 19715"/>
              <a:gd name="adj2" fmla="val 50000"/>
            </a:avLst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PT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B4028A4D-02C8-1653-1FCC-F71679011C78}"/>
              </a:ext>
            </a:extLst>
          </p:cNvPr>
          <p:cNvSpPr txBox="1"/>
          <p:nvPr/>
        </p:nvSpPr>
        <p:spPr>
          <a:xfrm>
            <a:off x="7547844" y="1470301"/>
            <a:ext cx="6826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WSN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04EF592D-F796-2959-3CEB-FB8B7D54B8FD}"/>
              </a:ext>
            </a:extLst>
          </p:cNvPr>
          <p:cNvSpPr txBox="1"/>
          <p:nvPr/>
        </p:nvSpPr>
        <p:spPr>
          <a:xfrm>
            <a:off x="8444854" y="1959160"/>
            <a:ext cx="6383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PT" sz="1200" dirty="0"/>
              <a:t>MDCK 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256CF609-9D0F-F372-CA10-5BCA369FDCBF}"/>
              </a:ext>
            </a:extLst>
          </p:cNvPr>
          <p:cNvSpPr txBox="1"/>
          <p:nvPr/>
        </p:nvSpPr>
        <p:spPr>
          <a:xfrm>
            <a:off x="9066934" y="1959160"/>
            <a:ext cx="4789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PT" sz="1200" dirty="0"/>
              <a:t>-HA </a:t>
            </a:r>
          </a:p>
        </p:txBody>
      </p:sp>
      <p:sp>
        <p:nvSpPr>
          <p:cNvPr id="25" name="Left Brace 24">
            <a:extLst>
              <a:ext uri="{FF2B5EF4-FFF2-40B4-BE49-F238E27FC236}">
                <a16:creationId xmlns:a16="http://schemas.microsoft.com/office/drawing/2014/main" id="{ACEF729F-847C-4747-859A-1567633AFC0C}"/>
              </a:ext>
            </a:extLst>
          </p:cNvPr>
          <p:cNvSpPr/>
          <p:nvPr/>
        </p:nvSpPr>
        <p:spPr>
          <a:xfrm rot="5400000">
            <a:off x="8857836" y="1376065"/>
            <a:ext cx="277000" cy="1099037"/>
          </a:xfrm>
          <a:prstGeom prst="leftBrace">
            <a:avLst>
              <a:gd name="adj1" fmla="val 19715"/>
              <a:gd name="adj2" fmla="val 50000"/>
            </a:avLst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PT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6B45D6FB-88B8-5D9E-A795-95A839628EF3}"/>
              </a:ext>
            </a:extLst>
          </p:cNvPr>
          <p:cNvSpPr txBox="1"/>
          <p:nvPr/>
        </p:nvSpPr>
        <p:spPr>
          <a:xfrm>
            <a:off x="8466606" y="1470301"/>
            <a:ext cx="9932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deltaHA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0826CA4F-A25F-C768-256A-8F323413FB5A}"/>
              </a:ext>
            </a:extLst>
          </p:cNvPr>
          <p:cNvSpPr txBox="1"/>
          <p:nvPr/>
        </p:nvSpPr>
        <p:spPr>
          <a:xfrm>
            <a:off x="9543892" y="1959160"/>
            <a:ext cx="6383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PT" sz="1200" dirty="0"/>
              <a:t>MDCK 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770D5897-AD81-8BBD-2A95-7A4259490FE4}"/>
              </a:ext>
            </a:extLst>
          </p:cNvPr>
          <p:cNvSpPr txBox="1"/>
          <p:nvPr/>
        </p:nvSpPr>
        <p:spPr>
          <a:xfrm>
            <a:off x="10165972" y="1959160"/>
            <a:ext cx="4789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PT" sz="1200" dirty="0"/>
              <a:t>-HA </a:t>
            </a:r>
          </a:p>
        </p:txBody>
      </p:sp>
      <p:sp>
        <p:nvSpPr>
          <p:cNvPr id="29" name="Left Brace 28">
            <a:extLst>
              <a:ext uri="{FF2B5EF4-FFF2-40B4-BE49-F238E27FC236}">
                <a16:creationId xmlns:a16="http://schemas.microsoft.com/office/drawing/2014/main" id="{5B66DD11-B5B6-A04C-CEA2-1C7EFDF7CF63}"/>
              </a:ext>
            </a:extLst>
          </p:cNvPr>
          <p:cNvSpPr/>
          <p:nvPr/>
        </p:nvSpPr>
        <p:spPr>
          <a:xfrm rot="5400000">
            <a:off x="9956874" y="1376065"/>
            <a:ext cx="277000" cy="1099037"/>
          </a:xfrm>
          <a:prstGeom prst="leftBrace">
            <a:avLst>
              <a:gd name="adj1" fmla="val 19715"/>
              <a:gd name="adj2" fmla="val 50000"/>
            </a:avLst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PT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519A2C96-8729-9720-5227-A9D2D810F941}"/>
              </a:ext>
            </a:extLst>
          </p:cNvPr>
          <p:cNvSpPr txBox="1"/>
          <p:nvPr/>
        </p:nvSpPr>
        <p:spPr>
          <a:xfrm>
            <a:off x="9745920" y="1470301"/>
            <a:ext cx="7280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Mock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A070BF23-FF1E-D34B-9950-29B99E39FD5A}"/>
              </a:ext>
            </a:extLst>
          </p:cNvPr>
          <p:cNvSpPr txBox="1"/>
          <p:nvPr/>
        </p:nvSpPr>
        <p:spPr>
          <a:xfrm>
            <a:off x="593432" y="3910819"/>
            <a:ext cx="8379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25 kda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8269E359-6DEE-7426-4721-ABC36933CAF4}"/>
              </a:ext>
            </a:extLst>
          </p:cNvPr>
          <p:cNvSpPr txBox="1"/>
          <p:nvPr/>
        </p:nvSpPr>
        <p:spPr>
          <a:xfrm>
            <a:off x="622849" y="4280151"/>
            <a:ext cx="8379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20 kda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ABA0A5A9-947F-B5B3-C042-4C62DF6BDC33}"/>
              </a:ext>
            </a:extLst>
          </p:cNvPr>
          <p:cNvSpPr txBox="1"/>
          <p:nvPr/>
        </p:nvSpPr>
        <p:spPr>
          <a:xfrm>
            <a:off x="593432" y="4771684"/>
            <a:ext cx="8379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17 kda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844BDBE7-9447-BC1A-69BC-5A4A888DE40D}"/>
              </a:ext>
            </a:extLst>
          </p:cNvPr>
          <p:cNvSpPr txBox="1"/>
          <p:nvPr/>
        </p:nvSpPr>
        <p:spPr>
          <a:xfrm>
            <a:off x="600527" y="5263217"/>
            <a:ext cx="8379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11 kda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951AEC40-A32D-76CC-F2DC-F65B2F8318CD}"/>
              </a:ext>
            </a:extLst>
          </p:cNvPr>
          <p:cNvSpPr txBox="1"/>
          <p:nvPr/>
        </p:nvSpPr>
        <p:spPr>
          <a:xfrm>
            <a:off x="5600888" y="3910819"/>
            <a:ext cx="8379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25 kda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E53F4E22-A058-7D3A-7275-174F31DB3047}"/>
              </a:ext>
            </a:extLst>
          </p:cNvPr>
          <p:cNvSpPr txBox="1"/>
          <p:nvPr/>
        </p:nvSpPr>
        <p:spPr>
          <a:xfrm>
            <a:off x="562952" y="3387970"/>
            <a:ext cx="8379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35 kda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E1C6CC08-719D-2703-7119-E0B4C96BB9FD}"/>
              </a:ext>
            </a:extLst>
          </p:cNvPr>
          <p:cNvSpPr txBox="1"/>
          <p:nvPr/>
        </p:nvSpPr>
        <p:spPr>
          <a:xfrm>
            <a:off x="562952" y="2896437"/>
            <a:ext cx="8379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48 kda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2EC07986-0D69-179C-9291-92E1A74CA64D}"/>
              </a:ext>
            </a:extLst>
          </p:cNvPr>
          <p:cNvSpPr txBox="1"/>
          <p:nvPr/>
        </p:nvSpPr>
        <p:spPr>
          <a:xfrm>
            <a:off x="562952" y="2542827"/>
            <a:ext cx="8379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63 kda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B39E31F4-80B5-5655-9757-D592AEAEE2D6}"/>
              </a:ext>
            </a:extLst>
          </p:cNvPr>
          <p:cNvSpPr txBox="1"/>
          <p:nvPr/>
        </p:nvSpPr>
        <p:spPr>
          <a:xfrm>
            <a:off x="522365" y="2090580"/>
            <a:ext cx="8379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75 kda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E85E40D8-62D3-5FA1-EE1C-BB897865DA3F}"/>
              </a:ext>
            </a:extLst>
          </p:cNvPr>
          <p:cNvSpPr txBox="1"/>
          <p:nvPr/>
        </p:nvSpPr>
        <p:spPr>
          <a:xfrm>
            <a:off x="493622" y="1879018"/>
            <a:ext cx="9614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100 kda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08E623F0-54DE-EB2B-56AC-26DFD174E2D4}"/>
              </a:ext>
            </a:extLst>
          </p:cNvPr>
          <p:cNvSpPr txBox="1"/>
          <p:nvPr/>
        </p:nvSpPr>
        <p:spPr>
          <a:xfrm>
            <a:off x="11107728" y="4012337"/>
            <a:ext cx="4908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M1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2AC2626E-A2CE-E131-3A61-1229F377C4FB}"/>
              </a:ext>
            </a:extLst>
          </p:cNvPr>
          <p:cNvSpPr txBox="1"/>
          <p:nvPr/>
        </p:nvSpPr>
        <p:spPr>
          <a:xfrm>
            <a:off x="11043528" y="2556194"/>
            <a:ext cx="4812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NP</a:t>
            </a:r>
          </a:p>
        </p:txBody>
      </p:sp>
    </p:spTree>
    <p:extLst>
      <p:ext uri="{BB962C8B-B14F-4D97-AF65-F5344CB8AC3E}">
        <p14:creationId xmlns:p14="http://schemas.microsoft.com/office/powerpoint/2010/main" val="164336110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E35EC9-A644-B653-C70F-75C42A2B54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74172" y="34984"/>
            <a:ext cx="10515600" cy="1325563"/>
          </a:xfrm>
        </p:spPr>
        <p:txBody>
          <a:bodyPr>
            <a:normAutofit/>
          </a:bodyPr>
          <a:lstStyle/>
          <a:p>
            <a:r>
              <a:rPr lang="en-PT" sz="4000" dirty="0"/>
              <a:t>Replicate 1 and 2, 4hpi and 8hpi timepoints</a:t>
            </a:r>
          </a:p>
        </p:txBody>
      </p:sp>
      <p:pic>
        <p:nvPicPr>
          <p:cNvPr id="14" name="Content Placeholder 13">
            <a:extLst>
              <a:ext uri="{FF2B5EF4-FFF2-40B4-BE49-F238E27FC236}">
                <a16:creationId xmlns:a16="http://schemas.microsoft.com/office/drawing/2014/main" id="{8614EAD9-AF66-5CE3-E3F9-ACD8B79E7F2C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/>
          <a:stretch>
            <a:fillRect/>
          </a:stretch>
        </p:blipFill>
        <p:spPr>
          <a:xfrm>
            <a:off x="2856591" y="1836217"/>
            <a:ext cx="4250362" cy="330339"/>
          </a:xfrm>
          <a:ln>
            <a:solidFill>
              <a:schemeClr val="tx1"/>
            </a:solidFill>
          </a:ln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939D7E5F-63C6-4DBF-BC6D-FCA1D24DEE5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889628" y="1337853"/>
            <a:ext cx="4184289" cy="30831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3F217A9C-BE92-5D35-E2E6-5E2562F2BFF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856596" y="2356604"/>
            <a:ext cx="4250353" cy="39640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E18831E1-177B-233A-463F-747A1348B75F}"/>
              </a:ext>
            </a:extLst>
          </p:cNvPr>
          <p:cNvSpPr txBox="1"/>
          <p:nvPr/>
        </p:nvSpPr>
        <p:spPr>
          <a:xfrm>
            <a:off x="174172" y="1836217"/>
            <a:ext cx="1683474" cy="35394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342900" indent="-342900">
              <a:buFont typeface="+mj-lt"/>
              <a:buAutoNum type="arabicPeriod"/>
            </a:pPr>
            <a:r>
              <a:rPr lang="en-PT" sz="1600" dirty="0"/>
              <a:t>R1 A549 4hpi</a:t>
            </a:r>
          </a:p>
          <a:p>
            <a:pPr marL="342900" indent="-342900">
              <a:buFont typeface="+mj-lt"/>
              <a:buAutoNum type="arabicPeriod"/>
            </a:pPr>
            <a:r>
              <a:rPr lang="en-PT" sz="1600" dirty="0"/>
              <a:t>R2 A549 4hpi</a:t>
            </a:r>
          </a:p>
          <a:p>
            <a:pPr marL="342900" indent="-342900">
              <a:buFont typeface="+mj-lt"/>
              <a:buAutoNum type="arabicPeriod"/>
            </a:pPr>
            <a:r>
              <a:rPr lang="en-PT" sz="1600" dirty="0"/>
              <a:t>R1 A549 8hpi</a:t>
            </a:r>
          </a:p>
          <a:p>
            <a:pPr marL="342900" indent="-342900">
              <a:buFont typeface="+mj-lt"/>
              <a:buAutoNum type="arabicPeriod"/>
            </a:pPr>
            <a:r>
              <a:rPr lang="en-PT" sz="1600" dirty="0"/>
              <a:t>R2 A549 8hpi</a:t>
            </a:r>
          </a:p>
          <a:p>
            <a:pPr marL="342900" indent="-342900">
              <a:buFont typeface="+mj-lt"/>
              <a:buAutoNum type="arabicPeriod"/>
            </a:pPr>
            <a:r>
              <a:rPr lang="en-PT" sz="1600" dirty="0"/>
              <a:t>R1 WT 4hpi</a:t>
            </a:r>
          </a:p>
          <a:p>
            <a:pPr marL="342900" indent="-342900">
              <a:buFont typeface="+mj-lt"/>
              <a:buAutoNum type="arabicPeriod"/>
            </a:pPr>
            <a:r>
              <a:rPr lang="en-PT" sz="1600" dirty="0"/>
              <a:t>R2 WT 4hpi</a:t>
            </a:r>
          </a:p>
          <a:p>
            <a:pPr marL="342900" indent="-342900">
              <a:buFont typeface="+mj-lt"/>
              <a:buAutoNum type="arabicPeriod"/>
            </a:pPr>
            <a:r>
              <a:rPr lang="en-PT" sz="1600" dirty="0"/>
              <a:t>R1 WT 8hpi</a:t>
            </a:r>
          </a:p>
          <a:p>
            <a:pPr marL="342900" indent="-342900">
              <a:buFont typeface="+mj-lt"/>
              <a:buAutoNum type="arabicPeriod"/>
            </a:pPr>
            <a:r>
              <a:rPr lang="en-PT" sz="1600" dirty="0"/>
              <a:t>R2 WT 8hpi</a:t>
            </a:r>
          </a:p>
          <a:p>
            <a:pPr marL="342900" indent="-342900">
              <a:buFont typeface="+mj-lt"/>
              <a:buAutoNum type="arabicPeriod"/>
            </a:pPr>
            <a:r>
              <a:rPr lang="en-PT" sz="1600" dirty="0"/>
              <a:t>R1 DN 4hpi</a:t>
            </a:r>
          </a:p>
          <a:p>
            <a:pPr marL="342900" indent="-342900">
              <a:buFont typeface="+mj-lt"/>
              <a:buAutoNum type="arabicPeriod"/>
            </a:pPr>
            <a:r>
              <a:rPr lang="en-PT" sz="1600" dirty="0"/>
              <a:t>R2 DN 4hpi</a:t>
            </a:r>
          </a:p>
          <a:p>
            <a:pPr marL="342900" indent="-342900">
              <a:buFont typeface="+mj-lt"/>
              <a:buAutoNum type="arabicPeriod"/>
            </a:pPr>
            <a:r>
              <a:rPr lang="en-PT" sz="1600" dirty="0"/>
              <a:t>R1 DN 8hpi</a:t>
            </a:r>
          </a:p>
          <a:p>
            <a:pPr marL="342900" indent="-342900">
              <a:buFont typeface="+mj-lt"/>
              <a:buAutoNum type="arabicPeriod"/>
            </a:pPr>
            <a:r>
              <a:rPr lang="en-PT" sz="1600" dirty="0"/>
              <a:t>R2 DN 8hpi</a:t>
            </a:r>
          </a:p>
          <a:p>
            <a:pPr marL="342900" indent="-342900">
              <a:buFont typeface="+mj-lt"/>
              <a:buAutoNum type="arabicPeriod"/>
            </a:pPr>
            <a:endParaRPr lang="en-PT" sz="1600" dirty="0"/>
          </a:p>
          <a:p>
            <a:pPr marL="342900" indent="-342900">
              <a:buFont typeface="+mj-lt"/>
              <a:buAutoNum type="arabicPeriod"/>
            </a:pPr>
            <a:endParaRPr lang="en-PT" sz="1600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C06FCDFC-021E-3ACD-BE69-66EB9E2A7454}"/>
              </a:ext>
            </a:extLst>
          </p:cNvPr>
          <p:cNvSpPr txBox="1"/>
          <p:nvPr/>
        </p:nvSpPr>
        <p:spPr>
          <a:xfrm>
            <a:off x="7106944" y="1339744"/>
            <a:ext cx="53572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sz="1600" dirty="0"/>
              <a:t>PB2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23E9724E-3E30-B390-E97F-24526459961B}"/>
              </a:ext>
            </a:extLst>
          </p:cNvPr>
          <p:cNvSpPr txBox="1"/>
          <p:nvPr/>
        </p:nvSpPr>
        <p:spPr>
          <a:xfrm>
            <a:off x="7106944" y="1828002"/>
            <a:ext cx="4475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sz="1600" dirty="0"/>
              <a:t>NP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EADCC13C-4392-6DCA-F34D-B4C0E7F064E7}"/>
              </a:ext>
            </a:extLst>
          </p:cNvPr>
          <p:cNvSpPr txBox="1"/>
          <p:nvPr/>
        </p:nvSpPr>
        <p:spPr>
          <a:xfrm>
            <a:off x="7106944" y="2385530"/>
            <a:ext cx="6415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sz="1600" dirty="0"/>
              <a:t>Actin</a:t>
            </a:r>
          </a:p>
        </p:txBody>
      </p:sp>
      <p:pic>
        <p:nvPicPr>
          <p:cNvPr id="24" name="Picture 23">
            <a:extLst>
              <a:ext uri="{FF2B5EF4-FFF2-40B4-BE49-F238E27FC236}">
                <a16:creationId xmlns:a16="http://schemas.microsoft.com/office/drawing/2014/main" id="{C21901C4-7AFA-60D3-5D11-AB3BEA5E367D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856591" y="3375516"/>
            <a:ext cx="4184275" cy="39640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12880699-E337-E958-57E9-640C8735EF68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856580" y="4485406"/>
            <a:ext cx="4184286" cy="39640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7" name="TextBox 26">
            <a:extLst>
              <a:ext uri="{FF2B5EF4-FFF2-40B4-BE49-F238E27FC236}">
                <a16:creationId xmlns:a16="http://schemas.microsoft.com/office/drawing/2014/main" id="{A0BE1291-FAD9-EA51-F47B-89091A00B9DE}"/>
              </a:ext>
            </a:extLst>
          </p:cNvPr>
          <p:cNvSpPr txBox="1"/>
          <p:nvPr/>
        </p:nvSpPr>
        <p:spPr>
          <a:xfrm>
            <a:off x="7104781" y="4514332"/>
            <a:ext cx="6415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sz="1600" dirty="0"/>
              <a:t>Actin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FE41B7E4-4C4C-0C7C-98E8-93D21421B143}"/>
              </a:ext>
            </a:extLst>
          </p:cNvPr>
          <p:cNvSpPr txBox="1"/>
          <p:nvPr/>
        </p:nvSpPr>
        <p:spPr>
          <a:xfrm>
            <a:off x="7104781" y="3404441"/>
            <a:ext cx="45076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sz="1600" dirty="0"/>
              <a:t>HA</a:t>
            </a:r>
          </a:p>
        </p:txBody>
      </p:sp>
      <p:pic>
        <p:nvPicPr>
          <p:cNvPr id="36" name="Picture 35">
            <a:extLst>
              <a:ext uri="{FF2B5EF4-FFF2-40B4-BE49-F238E27FC236}">
                <a16:creationId xmlns:a16="http://schemas.microsoft.com/office/drawing/2014/main" id="{91CB5D82-DB00-CA76-BD81-4600ED67D1A1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856580" y="3927878"/>
            <a:ext cx="4184286" cy="35422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7" name="TextBox 36">
            <a:extLst>
              <a:ext uri="{FF2B5EF4-FFF2-40B4-BE49-F238E27FC236}">
                <a16:creationId xmlns:a16="http://schemas.microsoft.com/office/drawing/2014/main" id="{8D6CBC3D-81CC-3301-F344-6AC47B8859F6}"/>
              </a:ext>
            </a:extLst>
          </p:cNvPr>
          <p:cNvSpPr txBox="1"/>
          <p:nvPr/>
        </p:nvSpPr>
        <p:spPr>
          <a:xfrm>
            <a:off x="7098127" y="3956804"/>
            <a:ext cx="55335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sz="1600" dirty="0"/>
              <a:t>NS1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392FA6CC-0F10-82E0-8B06-0407D323A9DF}"/>
              </a:ext>
            </a:extLst>
          </p:cNvPr>
          <p:cNvSpPr txBox="1"/>
          <p:nvPr/>
        </p:nvSpPr>
        <p:spPr>
          <a:xfrm>
            <a:off x="642257" y="5965371"/>
            <a:ext cx="23647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M</a:t>
            </a:r>
            <a:r>
              <a:rPr lang="en-PT" dirty="0"/>
              <a:t>ocks on another gel.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E41C1DF1-B820-1BD3-D612-3D5E3030CA48}"/>
              </a:ext>
            </a:extLst>
          </p:cNvPr>
          <p:cNvSpPr txBox="1"/>
          <p:nvPr/>
        </p:nvSpPr>
        <p:spPr>
          <a:xfrm>
            <a:off x="2856580" y="2729827"/>
            <a:ext cx="42675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 1     2     3    4      5    6    7      8      9   10  11  12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5E049E67-F3D5-F4CF-32EF-24AF483BDD20}"/>
              </a:ext>
            </a:extLst>
          </p:cNvPr>
          <p:cNvSpPr txBox="1"/>
          <p:nvPr/>
        </p:nvSpPr>
        <p:spPr>
          <a:xfrm>
            <a:off x="2810094" y="4895104"/>
            <a:ext cx="43140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  1     2    3    4      5     6    7     8     9   10  11  12</a:t>
            </a:r>
          </a:p>
        </p:txBody>
      </p:sp>
    </p:spTree>
    <p:extLst>
      <p:ext uri="{BB962C8B-B14F-4D97-AF65-F5344CB8AC3E}">
        <p14:creationId xmlns:p14="http://schemas.microsoft.com/office/powerpoint/2010/main" val="326234141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306ACA9-B21B-E15D-60D4-423BE635AE9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PT" dirty="0"/>
              <a:t>Rep 1 and 2 - order in previous slide</a:t>
            </a:r>
          </a:p>
        </p:txBody>
      </p:sp>
      <p:pic>
        <p:nvPicPr>
          <p:cNvPr id="5" name="Content Placeholder 4" descr="A close-up of a white background&#10;&#10;AI-generated content may be incorrect.">
            <a:extLst>
              <a:ext uri="{FF2B5EF4-FFF2-40B4-BE49-F238E27FC236}">
                <a16:creationId xmlns:a16="http://schemas.microsoft.com/office/drawing/2014/main" id="{4612FD3F-60A3-E7B6-4A52-4A1F248D7AA0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344215" y="2051296"/>
            <a:ext cx="5667347" cy="4133328"/>
          </a:xfrm>
        </p:spPr>
      </p:pic>
      <p:pic>
        <p:nvPicPr>
          <p:cNvPr id="7" name="Picture 6" descr="A close-up of a white background&#10;&#10;AI-generated content may be incorrect.">
            <a:extLst>
              <a:ext uri="{FF2B5EF4-FFF2-40B4-BE49-F238E27FC236}">
                <a16:creationId xmlns:a16="http://schemas.microsoft.com/office/drawing/2014/main" id="{C9F39C19-C529-EF0D-B121-5898615E24A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78988" y="2305256"/>
            <a:ext cx="5174812" cy="3456384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32FE307E-86CA-ECD8-1818-1445FB6E7542}"/>
              </a:ext>
            </a:extLst>
          </p:cNvPr>
          <p:cNvSpPr txBox="1"/>
          <p:nvPr/>
        </p:nvSpPr>
        <p:spPr>
          <a:xfrm>
            <a:off x="214" y="4402780"/>
            <a:ext cx="8379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48 kda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DD1AF21-DCFF-6CBC-9700-56D14D073ACE}"/>
              </a:ext>
            </a:extLst>
          </p:cNvPr>
          <p:cNvSpPr txBox="1"/>
          <p:nvPr/>
        </p:nvSpPr>
        <p:spPr>
          <a:xfrm>
            <a:off x="5792294" y="4033448"/>
            <a:ext cx="8379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25 kd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8D27EFE2-D689-F497-DADF-1C5323DFAE4D}"/>
              </a:ext>
            </a:extLst>
          </p:cNvPr>
          <p:cNvSpPr txBox="1"/>
          <p:nvPr/>
        </p:nvSpPr>
        <p:spPr>
          <a:xfrm>
            <a:off x="5792294" y="3541498"/>
            <a:ext cx="8379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35 kda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967E3126-CA7C-107F-C552-E17C9A7EE07E}"/>
              </a:ext>
            </a:extLst>
          </p:cNvPr>
          <p:cNvSpPr txBox="1"/>
          <p:nvPr/>
        </p:nvSpPr>
        <p:spPr>
          <a:xfrm>
            <a:off x="5832588" y="3184514"/>
            <a:ext cx="8379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48 kda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3B721AF8-B6B3-F554-CCC5-31400F45EF51}"/>
              </a:ext>
            </a:extLst>
          </p:cNvPr>
          <p:cNvSpPr txBox="1"/>
          <p:nvPr/>
        </p:nvSpPr>
        <p:spPr>
          <a:xfrm>
            <a:off x="5792294" y="2963550"/>
            <a:ext cx="8379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63 kda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368A706A-206F-D5FE-FFCF-39648DEEDD1E}"/>
              </a:ext>
            </a:extLst>
          </p:cNvPr>
          <p:cNvSpPr txBox="1"/>
          <p:nvPr/>
        </p:nvSpPr>
        <p:spPr>
          <a:xfrm>
            <a:off x="5812441" y="2753873"/>
            <a:ext cx="8379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75 kda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727BD846-8D57-E3D6-222C-034B2001A647}"/>
              </a:ext>
            </a:extLst>
          </p:cNvPr>
          <p:cNvSpPr txBox="1"/>
          <p:nvPr/>
        </p:nvSpPr>
        <p:spPr>
          <a:xfrm>
            <a:off x="79922" y="5300391"/>
            <a:ext cx="8379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25 kda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5C2E6B56-96D4-FBFF-163E-B23E22329627}"/>
              </a:ext>
            </a:extLst>
          </p:cNvPr>
          <p:cNvSpPr txBox="1"/>
          <p:nvPr/>
        </p:nvSpPr>
        <p:spPr>
          <a:xfrm>
            <a:off x="79922" y="5115725"/>
            <a:ext cx="8379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35 kda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51586C80-C454-05FC-25FC-5930F474F8D2}"/>
              </a:ext>
            </a:extLst>
          </p:cNvPr>
          <p:cNvSpPr txBox="1"/>
          <p:nvPr/>
        </p:nvSpPr>
        <p:spPr>
          <a:xfrm>
            <a:off x="51892" y="3935841"/>
            <a:ext cx="8379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63 kda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B996C4B1-0273-C9A9-0942-1D929C2D7EDA}"/>
              </a:ext>
            </a:extLst>
          </p:cNvPr>
          <p:cNvSpPr txBox="1"/>
          <p:nvPr/>
        </p:nvSpPr>
        <p:spPr>
          <a:xfrm>
            <a:off x="79922" y="3628172"/>
            <a:ext cx="8379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75 kda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8A9BC7F7-04BB-5899-0018-35256734FFA3}"/>
              </a:ext>
            </a:extLst>
          </p:cNvPr>
          <p:cNvSpPr txBox="1"/>
          <p:nvPr/>
        </p:nvSpPr>
        <p:spPr>
          <a:xfrm>
            <a:off x="51892" y="3135837"/>
            <a:ext cx="9614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100 kda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76A1FA02-8A42-7377-3DBD-6BBA672FB9C9}"/>
              </a:ext>
            </a:extLst>
          </p:cNvPr>
          <p:cNvSpPr txBox="1"/>
          <p:nvPr/>
        </p:nvSpPr>
        <p:spPr>
          <a:xfrm>
            <a:off x="1692166" y="6358759"/>
            <a:ext cx="16180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PB2, NP, actin 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5A48D280-188F-9C9C-0C8B-E09196B2C753}"/>
              </a:ext>
            </a:extLst>
          </p:cNvPr>
          <p:cNvSpPr txBox="1"/>
          <p:nvPr/>
        </p:nvSpPr>
        <p:spPr>
          <a:xfrm>
            <a:off x="8450318" y="6195135"/>
            <a:ext cx="11028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HA, actin</a:t>
            </a:r>
          </a:p>
        </p:txBody>
      </p:sp>
    </p:spTree>
    <p:extLst>
      <p:ext uri="{BB962C8B-B14F-4D97-AF65-F5344CB8AC3E}">
        <p14:creationId xmlns:p14="http://schemas.microsoft.com/office/powerpoint/2010/main" val="66950264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EC89745-3556-7656-878E-4192406A25D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FD8100-8D20-735A-33DF-EFDB7AE451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PT" dirty="0"/>
              <a:t>Rep 1 and 2 – NS1 – same gel as HA,actin 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8BA8C61B-719F-D3A8-87DB-C23EA83B9650}"/>
              </a:ext>
            </a:extLst>
          </p:cNvPr>
          <p:cNvSpPr txBox="1"/>
          <p:nvPr/>
        </p:nvSpPr>
        <p:spPr>
          <a:xfrm>
            <a:off x="133487" y="3155915"/>
            <a:ext cx="8379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48 kda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9CDDDD45-ED94-981F-73BA-96D49CF12C2B}"/>
              </a:ext>
            </a:extLst>
          </p:cNvPr>
          <p:cNvSpPr txBox="1"/>
          <p:nvPr/>
        </p:nvSpPr>
        <p:spPr>
          <a:xfrm>
            <a:off x="112327" y="4125270"/>
            <a:ext cx="8379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25 kda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3C8A799E-F003-4A5C-E97C-3F068BDCC2CF}"/>
              </a:ext>
            </a:extLst>
          </p:cNvPr>
          <p:cNvSpPr txBox="1"/>
          <p:nvPr/>
        </p:nvSpPr>
        <p:spPr>
          <a:xfrm>
            <a:off x="133487" y="3538833"/>
            <a:ext cx="8379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35 kda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4E7DD427-ABA7-329C-6CC3-4F781971582D}"/>
              </a:ext>
            </a:extLst>
          </p:cNvPr>
          <p:cNvSpPr txBox="1"/>
          <p:nvPr/>
        </p:nvSpPr>
        <p:spPr>
          <a:xfrm>
            <a:off x="112327" y="2877148"/>
            <a:ext cx="8379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63 kda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4C9264C5-CFC6-A68B-3A0A-279D47F5A790}"/>
              </a:ext>
            </a:extLst>
          </p:cNvPr>
          <p:cNvSpPr txBox="1"/>
          <p:nvPr/>
        </p:nvSpPr>
        <p:spPr>
          <a:xfrm>
            <a:off x="91167" y="2622418"/>
            <a:ext cx="8379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75 kda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98C1244C-FB9E-ED78-4AB0-5CA6B8C747AC}"/>
              </a:ext>
            </a:extLst>
          </p:cNvPr>
          <p:cNvSpPr txBox="1"/>
          <p:nvPr/>
        </p:nvSpPr>
        <p:spPr>
          <a:xfrm>
            <a:off x="1692166" y="6358759"/>
            <a:ext cx="6014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NS1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F2827793-D138-5A76-EDB9-8A7B8FB5F163}"/>
              </a:ext>
            </a:extLst>
          </p:cNvPr>
          <p:cNvSpPr txBox="1"/>
          <p:nvPr/>
        </p:nvSpPr>
        <p:spPr>
          <a:xfrm>
            <a:off x="1660634" y="2133600"/>
            <a:ext cx="5293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INF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78BC52B-31DF-364A-B5DA-B9D4F1E77484}"/>
              </a:ext>
            </a:extLst>
          </p:cNvPr>
          <p:cNvSpPr txBox="1"/>
          <p:nvPr/>
        </p:nvSpPr>
        <p:spPr>
          <a:xfrm>
            <a:off x="6752896" y="2043930"/>
            <a:ext cx="8274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MOCK</a:t>
            </a:r>
          </a:p>
        </p:txBody>
      </p:sp>
      <p:pic>
        <p:nvPicPr>
          <p:cNvPr id="10" name="Picture 9" descr="A close-up of a dna test&#10;&#10;AI-generated content may be incorrect.">
            <a:extLst>
              <a:ext uri="{FF2B5EF4-FFF2-40B4-BE49-F238E27FC236}">
                <a16:creationId xmlns:a16="http://schemas.microsoft.com/office/drawing/2014/main" id="{73E7E472-7ABB-9229-F057-175B16AA6D3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31923" y="2502932"/>
            <a:ext cx="10515600" cy="3274986"/>
          </a:xfrm>
          <a:prstGeom prst="rect">
            <a:avLst/>
          </a:prstGeom>
        </p:spPr>
      </p:pic>
      <p:sp>
        <p:nvSpPr>
          <p:cNvPr id="24" name="TextBox 23">
            <a:extLst>
              <a:ext uri="{FF2B5EF4-FFF2-40B4-BE49-F238E27FC236}">
                <a16:creationId xmlns:a16="http://schemas.microsoft.com/office/drawing/2014/main" id="{C017D374-0665-CE99-3C08-80C2BEFB950D}"/>
              </a:ext>
            </a:extLst>
          </p:cNvPr>
          <p:cNvSpPr txBox="1"/>
          <p:nvPr/>
        </p:nvSpPr>
        <p:spPr>
          <a:xfrm>
            <a:off x="11407973" y="3026638"/>
            <a:ext cx="8379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48 kda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103A0B2D-752E-C69B-EF62-E844E5C15539}"/>
              </a:ext>
            </a:extLst>
          </p:cNvPr>
          <p:cNvSpPr txBox="1"/>
          <p:nvPr/>
        </p:nvSpPr>
        <p:spPr>
          <a:xfrm>
            <a:off x="11417168" y="4023548"/>
            <a:ext cx="8379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25 kda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C7B40E40-CE6D-A52D-0691-8EA203FC586B}"/>
              </a:ext>
            </a:extLst>
          </p:cNvPr>
          <p:cNvSpPr txBox="1"/>
          <p:nvPr/>
        </p:nvSpPr>
        <p:spPr>
          <a:xfrm>
            <a:off x="11438328" y="3437111"/>
            <a:ext cx="8379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35 kda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DDE955C0-9ECE-1556-3F7D-BF349539448A}"/>
              </a:ext>
            </a:extLst>
          </p:cNvPr>
          <p:cNvSpPr txBox="1"/>
          <p:nvPr/>
        </p:nvSpPr>
        <p:spPr>
          <a:xfrm>
            <a:off x="11400501" y="4392880"/>
            <a:ext cx="7914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20kda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A6D0A2CA-1F52-098D-5C7E-FD18EAC47074}"/>
              </a:ext>
            </a:extLst>
          </p:cNvPr>
          <p:cNvSpPr txBox="1"/>
          <p:nvPr/>
        </p:nvSpPr>
        <p:spPr>
          <a:xfrm>
            <a:off x="11353800" y="4946878"/>
            <a:ext cx="7914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17kda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0A78A086-0701-F175-708E-A936B01E3893}"/>
              </a:ext>
            </a:extLst>
          </p:cNvPr>
          <p:cNvSpPr txBox="1"/>
          <p:nvPr/>
        </p:nvSpPr>
        <p:spPr>
          <a:xfrm>
            <a:off x="177460" y="4473709"/>
            <a:ext cx="7914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20kda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2CD3C5AD-CAD7-595D-3ABA-71686DDA33C4}"/>
              </a:ext>
            </a:extLst>
          </p:cNvPr>
          <p:cNvSpPr txBox="1"/>
          <p:nvPr/>
        </p:nvSpPr>
        <p:spPr>
          <a:xfrm>
            <a:off x="177459" y="5060146"/>
            <a:ext cx="7914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17kda</a:t>
            </a:r>
          </a:p>
        </p:txBody>
      </p:sp>
    </p:spTree>
    <p:extLst>
      <p:ext uri="{BB962C8B-B14F-4D97-AF65-F5344CB8AC3E}">
        <p14:creationId xmlns:p14="http://schemas.microsoft.com/office/powerpoint/2010/main" val="178654096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C3D0C46-D4F0-7FE2-8A18-AD1732BD531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B5E386EF-4306-941F-C9F6-A29CACDEF98F}"/>
              </a:ext>
            </a:extLst>
          </p:cNvPr>
          <p:cNvSpPr txBox="1"/>
          <p:nvPr/>
        </p:nvSpPr>
        <p:spPr>
          <a:xfrm>
            <a:off x="578069" y="945931"/>
            <a:ext cx="9547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MOCKS</a:t>
            </a:r>
          </a:p>
        </p:txBody>
      </p:sp>
      <p:pic>
        <p:nvPicPr>
          <p:cNvPr id="9" name="Picture 8" descr="A close-up of a white background&#10;&#10;AI-generated content may be incorrect.">
            <a:extLst>
              <a:ext uri="{FF2B5EF4-FFF2-40B4-BE49-F238E27FC236}">
                <a16:creationId xmlns:a16="http://schemas.microsoft.com/office/drawing/2014/main" id="{C978CEA1-3769-AB11-4CDB-5D89751EE90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65638" y="2351789"/>
            <a:ext cx="5330362" cy="3560280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545E9184-0C32-3CB0-72D3-145D6BBBE082}"/>
              </a:ext>
            </a:extLst>
          </p:cNvPr>
          <p:cNvSpPr txBox="1"/>
          <p:nvPr/>
        </p:nvSpPr>
        <p:spPr>
          <a:xfrm>
            <a:off x="1969477" y="6288258"/>
            <a:ext cx="27648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A</a:t>
            </a:r>
            <a:r>
              <a:rPr lang="en-PT" dirty="0"/>
              <a:t>ctin, NP and PB2 stained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4D21DC8F-7764-A654-FB0A-B42D4C6B7BCD}"/>
              </a:ext>
            </a:extLst>
          </p:cNvPr>
          <p:cNvSpPr txBox="1"/>
          <p:nvPr/>
        </p:nvSpPr>
        <p:spPr>
          <a:xfrm>
            <a:off x="519637" y="4389120"/>
            <a:ext cx="7914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48kda</a:t>
            </a:r>
          </a:p>
        </p:txBody>
      </p:sp>
      <p:pic>
        <p:nvPicPr>
          <p:cNvPr id="13" name="Picture 12" descr="A close-up of a black and white photo&#10;&#10;AI-generated content may be incorrect.">
            <a:extLst>
              <a:ext uri="{FF2B5EF4-FFF2-40B4-BE49-F238E27FC236}">
                <a16:creationId xmlns:a16="http://schemas.microsoft.com/office/drawing/2014/main" id="{3B1C8ADA-3274-2BB3-ACCF-49D164B1439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96000" y="2351789"/>
            <a:ext cx="5330362" cy="3560280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9327E76A-8708-0EE8-47E2-00ACD2354385}"/>
              </a:ext>
            </a:extLst>
          </p:cNvPr>
          <p:cNvSpPr txBox="1"/>
          <p:nvPr/>
        </p:nvSpPr>
        <p:spPr>
          <a:xfrm>
            <a:off x="7920111" y="6288258"/>
            <a:ext cx="18992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A</a:t>
            </a:r>
            <a:r>
              <a:rPr lang="en-PT" dirty="0"/>
              <a:t>ctin, HA stained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E73FB1DA-5C80-3C09-628C-4309CC485343}"/>
              </a:ext>
            </a:extLst>
          </p:cNvPr>
          <p:cNvSpPr txBox="1"/>
          <p:nvPr/>
        </p:nvSpPr>
        <p:spPr>
          <a:xfrm>
            <a:off x="6044726" y="3172210"/>
            <a:ext cx="7914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48kda</a:t>
            </a:r>
          </a:p>
        </p:txBody>
      </p:sp>
    </p:spTree>
    <p:extLst>
      <p:ext uri="{BB962C8B-B14F-4D97-AF65-F5344CB8AC3E}">
        <p14:creationId xmlns:p14="http://schemas.microsoft.com/office/powerpoint/2010/main" val="36593798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28468771-1940-860E-3683-0ED8D2DA2A1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2430" y="2873460"/>
            <a:ext cx="3897992" cy="39394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C7FA5365-7852-BA79-D98F-8CFD13AA2E1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92430" y="2381643"/>
            <a:ext cx="3897992" cy="39394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7D222C0E-A975-B97F-D12B-35941AE4170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92433" y="1887366"/>
            <a:ext cx="3897987" cy="39640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" name="Title 1">
            <a:extLst>
              <a:ext uri="{FF2B5EF4-FFF2-40B4-BE49-F238E27FC236}">
                <a16:creationId xmlns:a16="http://schemas.microsoft.com/office/drawing/2014/main" id="{1947E222-0465-54EE-0B62-30FDEA657F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74172" y="34984"/>
            <a:ext cx="10515600" cy="1325563"/>
          </a:xfrm>
        </p:spPr>
        <p:txBody>
          <a:bodyPr>
            <a:normAutofit/>
          </a:bodyPr>
          <a:lstStyle/>
          <a:p>
            <a:r>
              <a:rPr lang="en-PT" sz="4000" dirty="0"/>
              <a:t>Replicate 1 and 2, 4hpi and 8hpi timepoints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597DD42-0BE4-BBA7-3BBA-0F040F3E7443}"/>
              </a:ext>
            </a:extLst>
          </p:cNvPr>
          <p:cNvSpPr txBox="1"/>
          <p:nvPr/>
        </p:nvSpPr>
        <p:spPr>
          <a:xfrm>
            <a:off x="1360713" y="1360714"/>
            <a:ext cx="12974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Replicate 1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318AA5F-58E1-EE03-EE25-231F1888940D}"/>
              </a:ext>
            </a:extLst>
          </p:cNvPr>
          <p:cNvSpPr txBox="1"/>
          <p:nvPr/>
        </p:nvSpPr>
        <p:spPr>
          <a:xfrm>
            <a:off x="7053942" y="1259518"/>
            <a:ext cx="12974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Replicate 2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371B890C-73AF-A225-999D-CF7585649A10}"/>
              </a:ext>
            </a:extLst>
          </p:cNvPr>
          <p:cNvSpPr txBox="1"/>
          <p:nvPr/>
        </p:nvSpPr>
        <p:spPr>
          <a:xfrm>
            <a:off x="4579670" y="1898894"/>
            <a:ext cx="4908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M1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297B89EA-5580-7D1F-270E-B5D13AD8E1DF}"/>
              </a:ext>
            </a:extLst>
          </p:cNvPr>
          <p:cNvSpPr txBox="1"/>
          <p:nvPr/>
        </p:nvSpPr>
        <p:spPr>
          <a:xfrm>
            <a:off x="4579670" y="2414998"/>
            <a:ext cx="4908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M2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557369A9-479F-285F-74D2-E6B437F25C7C}"/>
              </a:ext>
            </a:extLst>
          </p:cNvPr>
          <p:cNvSpPr txBox="1"/>
          <p:nvPr/>
        </p:nvSpPr>
        <p:spPr>
          <a:xfrm>
            <a:off x="4475475" y="2869057"/>
            <a:ext cx="6992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Actin</a:t>
            </a: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4AE71A1C-3A95-1ED6-830B-5897A850250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364227" y="2356507"/>
            <a:ext cx="4407395" cy="37509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A2EF8511-EA7E-16F7-CE8A-6F5C706C746A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398099" y="2885767"/>
            <a:ext cx="4339651" cy="36933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9501F20A-218C-B9C9-91B1-F5F79C70E579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364227" y="1916458"/>
            <a:ext cx="4407395" cy="28588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FC083912-DF33-C417-A240-E1D03EF31D8A}"/>
              </a:ext>
            </a:extLst>
          </p:cNvPr>
          <p:cNvSpPr txBox="1"/>
          <p:nvPr/>
        </p:nvSpPr>
        <p:spPr>
          <a:xfrm>
            <a:off x="392430" y="3619612"/>
            <a:ext cx="2916827" cy="35394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42900" indent="-342900">
              <a:buFont typeface="+mj-lt"/>
              <a:buAutoNum type="arabicPeriod"/>
            </a:pPr>
            <a:r>
              <a:rPr lang="en-PT" sz="1600" dirty="0"/>
              <a:t>A549 4hpi</a:t>
            </a:r>
          </a:p>
          <a:p>
            <a:pPr marL="342900" indent="-342900">
              <a:buFont typeface="+mj-lt"/>
              <a:buAutoNum type="arabicPeriod"/>
            </a:pPr>
            <a:r>
              <a:rPr lang="en-PT" sz="1600" dirty="0"/>
              <a:t>A549 4hpi mock</a:t>
            </a:r>
          </a:p>
          <a:p>
            <a:pPr marL="342900" indent="-342900">
              <a:buFont typeface="+mj-lt"/>
              <a:buAutoNum type="arabicPeriod"/>
            </a:pPr>
            <a:r>
              <a:rPr lang="en-PT" sz="1600" dirty="0"/>
              <a:t>A549 8hpi </a:t>
            </a:r>
          </a:p>
          <a:p>
            <a:pPr marL="342900" indent="-342900">
              <a:buFont typeface="+mj-lt"/>
              <a:buAutoNum type="arabicPeriod"/>
            </a:pPr>
            <a:r>
              <a:rPr lang="en-PT" sz="1600" dirty="0"/>
              <a:t>A549 8hpi mock</a:t>
            </a:r>
          </a:p>
          <a:p>
            <a:pPr marL="342900" indent="-342900">
              <a:buFont typeface="+mj-lt"/>
              <a:buAutoNum type="arabicPeriod"/>
            </a:pPr>
            <a:r>
              <a:rPr lang="en-PT" sz="1600" dirty="0"/>
              <a:t>WT 4hpi</a:t>
            </a:r>
          </a:p>
          <a:p>
            <a:pPr marL="342900" indent="-342900">
              <a:buFont typeface="+mj-lt"/>
              <a:buAutoNum type="arabicPeriod"/>
            </a:pPr>
            <a:r>
              <a:rPr lang="en-PT" sz="1600" dirty="0"/>
              <a:t>WT 4hpi mock</a:t>
            </a:r>
          </a:p>
          <a:p>
            <a:pPr marL="342900" indent="-342900">
              <a:buFont typeface="+mj-lt"/>
              <a:buAutoNum type="arabicPeriod"/>
            </a:pPr>
            <a:r>
              <a:rPr lang="en-PT" sz="1600" dirty="0"/>
              <a:t>WT 8hpi</a:t>
            </a:r>
          </a:p>
          <a:p>
            <a:pPr marL="342900" indent="-342900">
              <a:buFont typeface="+mj-lt"/>
              <a:buAutoNum type="arabicPeriod"/>
            </a:pPr>
            <a:r>
              <a:rPr lang="en-PT" sz="1600" dirty="0"/>
              <a:t>WT 8hpi mock</a:t>
            </a:r>
          </a:p>
          <a:p>
            <a:pPr marL="342900" indent="-342900">
              <a:buFont typeface="+mj-lt"/>
              <a:buAutoNum type="arabicPeriod"/>
            </a:pPr>
            <a:r>
              <a:rPr lang="en-PT" sz="1600" dirty="0"/>
              <a:t>DN 4hpi</a:t>
            </a:r>
          </a:p>
          <a:p>
            <a:pPr marL="342900" indent="-342900">
              <a:buFont typeface="+mj-lt"/>
              <a:buAutoNum type="arabicPeriod"/>
            </a:pPr>
            <a:r>
              <a:rPr lang="en-PT" sz="1600" dirty="0"/>
              <a:t>DN 4hpi mock</a:t>
            </a:r>
          </a:p>
          <a:p>
            <a:pPr marL="342900" indent="-342900">
              <a:buFont typeface="+mj-lt"/>
              <a:buAutoNum type="arabicPeriod"/>
            </a:pPr>
            <a:r>
              <a:rPr lang="en-PT" sz="1600" dirty="0"/>
              <a:t>DN 8hpi</a:t>
            </a:r>
          </a:p>
          <a:p>
            <a:pPr marL="342900" indent="-342900">
              <a:buFont typeface="+mj-lt"/>
              <a:buAutoNum type="arabicPeriod"/>
            </a:pPr>
            <a:r>
              <a:rPr lang="en-PT" sz="1600" dirty="0"/>
              <a:t>DN 8hpi mock</a:t>
            </a:r>
          </a:p>
          <a:p>
            <a:pPr marL="342900" indent="-342900">
              <a:buFont typeface="+mj-lt"/>
              <a:buAutoNum type="arabicPeriod"/>
            </a:pPr>
            <a:endParaRPr lang="en-PT" sz="1600" dirty="0"/>
          </a:p>
          <a:p>
            <a:pPr marL="342900" indent="-342900">
              <a:buFont typeface="+mj-lt"/>
              <a:buAutoNum type="arabicPeriod"/>
            </a:pPr>
            <a:endParaRPr lang="en-PT" sz="1600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B8379B38-EC25-477A-2DE0-77A64F507346}"/>
              </a:ext>
            </a:extLst>
          </p:cNvPr>
          <p:cNvSpPr txBox="1"/>
          <p:nvPr/>
        </p:nvSpPr>
        <p:spPr>
          <a:xfrm>
            <a:off x="392430" y="3266083"/>
            <a:ext cx="39885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 1    2     3    4    5   6     7     8    9   10  11 12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73904788-5A19-9BCB-7BE7-1AF1A32490B0}"/>
              </a:ext>
            </a:extLst>
          </p:cNvPr>
          <p:cNvSpPr txBox="1"/>
          <p:nvPr/>
        </p:nvSpPr>
        <p:spPr>
          <a:xfrm>
            <a:off x="5364226" y="3266083"/>
            <a:ext cx="43735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PT" dirty="0"/>
              <a:t>  1    2     3     4      5     6    7     8      9    10   11  12</a:t>
            </a:r>
          </a:p>
        </p:txBody>
      </p:sp>
    </p:spTree>
    <p:extLst>
      <p:ext uri="{BB962C8B-B14F-4D97-AF65-F5344CB8AC3E}">
        <p14:creationId xmlns:p14="http://schemas.microsoft.com/office/powerpoint/2010/main" val="62704421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707D71-06E1-88EB-6D27-2C480845611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PT" dirty="0"/>
              <a:t>Rep 1 and 2 4h 8h – M2</a:t>
            </a:r>
          </a:p>
        </p:txBody>
      </p:sp>
      <p:pic>
        <p:nvPicPr>
          <p:cNvPr id="5" name="Content Placeholder 4" descr="A close-up of a dna strand&#10;&#10;AI-generated content may be incorrect.">
            <a:extLst>
              <a:ext uri="{FF2B5EF4-FFF2-40B4-BE49-F238E27FC236}">
                <a16:creationId xmlns:a16="http://schemas.microsoft.com/office/drawing/2014/main" id="{3F548101-B717-89E9-60D0-F8E1218504CD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6096000" y="1534881"/>
            <a:ext cx="5130018" cy="4477897"/>
          </a:xfr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61ACCB0F-FECC-1791-3841-51ECA3B13CE1}"/>
              </a:ext>
            </a:extLst>
          </p:cNvPr>
          <p:cNvSpPr txBox="1"/>
          <p:nvPr/>
        </p:nvSpPr>
        <p:spPr>
          <a:xfrm>
            <a:off x="11080244" y="5039977"/>
            <a:ext cx="4908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M2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3C28E74-A918-8442-AB91-413FD58C7CFA}"/>
              </a:ext>
            </a:extLst>
          </p:cNvPr>
          <p:cNvSpPr txBox="1"/>
          <p:nvPr/>
        </p:nvSpPr>
        <p:spPr>
          <a:xfrm>
            <a:off x="5700250" y="5138453"/>
            <a:ext cx="7914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17kd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496B1F8-5B20-ED45-9A7A-92A099BA1770}"/>
              </a:ext>
            </a:extLst>
          </p:cNvPr>
          <p:cNvSpPr txBox="1"/>
          <p:nvPr/>
        </p:nvSpPr>
        <p:spPr>
          <a:xfrm>
            <a:off x="5700249" y="4670645"/>
            <a:ext cx="7914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20kd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ADAF890-A0AC-7BCC-B9ED-3107DFC0EAB8}"/>
              </a:ext>
            </a:extLst>
          </p:cNvPr>
          <p:cNvSpPr txBox="1"/>
          <p:nvPr/>
        </p:nvSpPr>
        <p:spPr>
          <a:xfrm>
            <a:off x="5700248" y="4387503"/>
            <a:ext cx="7914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25kd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9107A19-77DD-71C0-64BB-53EA48905094}"/>
              </a:ext>
            </a:extLst>
          </p:cNvPr>
          <p:cNvSpPr txBox="1"/>
          <p:nvPr/>
        </p:nvSpPr>
        <p:spPr>
          <a:xfrm>
            <a:off x="5700247" y="3876600"/>
            <a:ext cx="7914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35kd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A629A90E-9AC2-62F5-C112-44F34F904E49}"/>
              </a:ext>
            </a:extLst>
          </p:cNvPr>
          <p:cNvSpPr txBox="1"/>
          <p:nvPr/>
        </p:nvSpPr>
        <p:spPr>
          <a:xfrm>
            <a:off x="5647489" y="3521500"/>
            <a:ext cx="7914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48kda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2525B801-0D83-BC72-22B4-765F5A19B0EC}"/>
              </a:ext>
            </a:extLst>
          </p:cNvPr>
          <p:cNvSpPr txBox="1"/>
          <p:nvPr/>
        </p:nvSpPr>
        <p:spPr>
          <a:xfrm>
            <a:off x="10980598" y="3486614"/>
            <a:ext cx="6864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actin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BA33D666-DE9A-19A1-2E2B-6A1B23FA3FA0}"/>
              </a:ext>
            </a:extLst>
          </p:cNvPr>
          <p:cNvSpPr txBox="1"/>
          <p:nvPr/>
        </p:nvSpPr>
        <p:spPr>
          <a:xfrm>
            <a:off x="6504637" y="6123543"/>
            <a:ext cx="549586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M</a:t>
            </a:r>
            <a:r>
              <a:rPr lang="en-PT" dirty="0"/>
              <a:t>embrane got cut so only used M2 here, M1 ab didn’t </a:t>
            </a:r>
          </a:p>
          <a:p>
            <a:r>
              <a:rPr lang="en-GB" dirty="0"/>
              <a:t>W</a:t>
            </a:r>
            <a:r>
              <a:rPr lang="en-PT" dirty="0"/>
              <a:t>ork so restained for that</a:t>
            </a:r>
          </a:p>
        </p:txBody>
      </p:sp>
      <p:pic>
        <p:nvPicPr>
          <p:cNvPr id="15" name="Picture 14" descr="A black and white photo of a bridge&#10;&#10;AI-generated content may be incorrect.">
            <a:extLst>
              <a:ext uri="{FF2B5EF4-FFF2-40B4-BE49-F238E27FC236}">
                <a16:creationId xmlns:a16="http://schemas.microsoft.com/office/drawing/2014/main" id="{CC64E61C-608D-D178-78DC-D9EBECF4DD7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21434822">
            <a:off x="412059" y="1852391"/>
            <a:ext cx="5232215" cy="456710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4173437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EA909C3-1D7D-4DF3-2BBE-72E2E146493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Picture 14" descr="A close-up of a dna test&#10;&#10;AI-generated content may be incorrect.">
            <a:extLst>
              <a:ext uri="{FF2B5EF4-FFF2-40B4-BE49-F238E27FC236}">
                <a16:creationId xmlns:a16="http://schemas.microsoft.com/office/drawing/2014/main" id="{E9AC1E22-77C7-7A30-EFF6-8A53406DE30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979090" y="2723887"/>
            <a:ext cx="5508292" cy="2754146"/>
          </a:xfrm>
          <a:prstGeom prst="rect">
            <a:avLst/>
          </a:prstGeo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11DD9A0F-7E48-978C-3846-69FA3596E32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PT" dirty="0"/>
              <a:t>Rep 1 and 2 4h 8h – M1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D34EA6E9-4256-D3E5-0797-45682FC95E2B}"/>
              </a:ext>
            </a:extLst>
          </p:cNvPr>
          <p:cNvSpPr txBox="1"/>
          <p:nvPr/>
        </p:nvSpPr>
        <p:spPr>
          <a:xfrm>
            <a:off x="11241962" y="4517047"/>
            <a:ext cx="4908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M2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4444DF49-3250-5166-3471-0BCF16C278E3}"/>
              </a:ext>
            </a:extLst>
          </p:cNvPr>
          <p:cNvSpPr txBox="1"/>
          <p:nvPr/>
        </p:nvSpPr>
        <p:spPr>
          <a:xfrm>
            <a:off x="5570498" y="4485168"/>
            <a:ext cx="7914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17kd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CAA0264-9325-C6CD-A305-8723C113FC10}"/>
              </a:ext>
            </a:extLst>
          </p:cNvPr>
          <p:cNvSpPr txBox="1"/>
          <p:nvPr/>
        </p:nvSpPr>
        <p:spPr>
          <a:xfrm>
            <a:off x="5528647" y="4115836"/>
            <a:ext cx="7914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20kd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903D3A8-DCCE-DFEE-C301-17FCAF36F972}"/>
              </a:ext>
            </a:extLst>
          </p:cNvPr>
          <p:cNvSpPr txBox="1"/>
          <p:nvPr/>
        </p:nvSpPr>
        <p:spPr>
          <a:xfrm>
            <a:off x="5443920" y="3746504"/>
            <a:ext cx="7914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25kda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20EAA2D9-6BC1-FAD3-8F7A-78961CDAF9C0}"/>
              </a:ext>
            </a:extLst>
          </p:cNvPr>
          <p:cNvSpPr txBox="1"/>
          <p:nvPr/>
        </p:nvSpPr>
        <p:spPr>
          <a:xfrm>
            <a:off x="5583340" y="4886379"/>
            <a:ext cx="7914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11kda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0E576A71-C577-387E-2750-F87261759578}"/>
              </a:ext>
            </a:extLst>
          </p:cNvPr>
          <p:cNvSpPr txBox="1"/>
          <p:nvPr/>
        </p:nvSpPr>
        <p:spPr>
          <a:xfrm>
            <a:off x="11228241" y="3602762"/>
            <a:ext cx="4908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M1</a:t>
            </a:r>
          </a:p>
        </p:txBody>
      </p:sp>
      <p:pic>
        <p:nvPicPr>
          <p:cNvPr id="20" name="Picture 19" descr="A close-up of a white sheet&#10;&#10;AI-generated content may be incorrect.">
            <a:extLst>
              <a:ext uri="{FF2B5EF4-FFF2-40B4-BE49-F238E27FC236}">
                <a16:creationId xmlns:a16="http://schemas.microsoft.com/office/drawing/2014/main" id="{7E82EC54-A986-F76A-DF63-176790E4D99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86336" y="3088490"/>
            <a:ext cx="4848046" cy="2424023"/>
          </a:xfrm>
          <a:prstGeom prst="rect">
            <a:avLst/>
          </a:prstGeom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A18660C3-84EE-E6F8-BE9D-CE2FD6A014F2}"/>
              </a:ext>
            </a:extLst>
          </p:cNvPr>
          <p:cNvSpPr txBox="1"/>
          <p:nvPr/>
        </p:nvSpPr>
        <p:spPr>
          <a:xfrm>
            <a:off x="1885071" y="2799471"/>
            <a:ext cx="4475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R1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A738982C-F664-16F6-E711-D01A5788A0D9}"/>
              </a:ext>
            </a:extLst>
          </p:cNvPr>
          <p:cNvSpPr txBox="1"/>
          <p:nvPr/>
        </p:nvSpPr>
        <p:spPr>
          <a:xfrm>
            <a:off x="8509457" y="2799471"/>
            <a:ext cx="4475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R2</a:t>
            </a:r>
          </a:p>
        </p:txBody>
      </p:sp>
    </p:spTree>
    <p:extLst>
      <p:ext uri="{BB962C8B-B14F-4D97-AF65-F5344CB8AC3E}">
        <p14:creationId xmlns:p14="http://schemas.microsoft.com/office/powerpoint/2010/main" val="351715580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E35EC9-A644-B653-C70F-75C42A2B54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74172" y="34984"/>
            <a:ext cx="10515600" cy="1325563"/>
          </a:xfrm>
        </p:spPr>
        <p:txBody>
          <a:bodyPr>
            <a:normAutofit/>
          </a:bodyPr>
          <a:lstStyle/>
          <a:p>
            <a:r>
              <a:rPr lang="en-PT" sz="4000" dirty="0"/>
              <a:t>Replicate 1 and 2, 12hpi and 16hpi timepoints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E18831E1-177B-233A-463F-747A1348B75F}"/>
              </a:ext>
            </a:extLst>
          </p:cNvPr>
          <p:cNvSpPr txBox="1"/>
          <p:nvPr/>
        </p:nvSpPr>
        <p:spPr>
          <a:xfrm>
            <a:off x="174172" y="1836217"/>
            <a:ext cx="2053767" cy="35394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342900" indent="-342900">
              <a:buFont typeface="+mj-lt"/>
              <a:buAutoNum type="arabicPeriod"/>
            </a:pPr>
            <a:r>
              <a:rPr lang="en-PT" sz="1600" dirty="0"/>
              <a:t>A549 12hpi</a:t>
            </a:r>
          </a:p>
          <a:p>
            <a:pPr marL="342900" indent="-342900">
              <a:buFont typeface="+mj-lt"/>
              <a:buAutoNum type="arabicPeriod"/>
            </a:pPr>
            <a:r>
              <a:rPr lang="en-PT" sz="1600" dirty="0"/>
              <a:t>A549 12hpi mock</a:t>
            </a:r>
          </a:p>
          <a:p>
            <a:pPr marL="342900" indent="-342900">
              <a:buFont typeface="+mj-lt"/>
              <a:buAutoNum type="arabicPeriod"/>
            </a:pPr>
            <a:r>
              <a:rPr lang="en-PT" sz="1600" dirty="0"/>
              <a:t>A549 16hpi</a:t>
            </a:r>
          </a:p>
          <a:p>
            <a:pPr marL="342900" indent="-342900">
              <a:buFont typeface="+mj-lt"/>
              <a:buAutoNum type="arabicPeriod"/>
            </a:pPr>
            <a:r>
              <a:rPr lang="en-PT" sz="1600" dirty="0"/>
              <a:t>A549 16hpi mock</a:t>
            </a:r>
          </a:p>
          <a:p>
            <a:pPr marL="342900" indent="-342900">
              <a:buFont typeface="+mj-lt"/>
              <a:buAutoNum type="arabicPeriod"/>
            </a:pPr>
            <a:r>
              <a:rPr lang="en-PT" sz="1600" dirty="0"/>
              <a:t>WT 16hpi</a:t>
            </a:r>
          </a:p>
          <a:p>
            <a:pPr marL="342900" indent="-342900">
              <a:buFont typeface="+mj-lt"/>
              <a:buAutoNum type="arabicPeriod"/>
            </a:pPr>
            <a:r>
              <a:rPr lang="en-PT" sz="1600" dirty="0"/>
              <a:t>WT 16hpi mock</a:t>
            </a:r>
          </a:p>
          <a:p>
            <a:pPr marL="342900" indent="-342900">
              <a:buFont typeface="+mj-lt"/>
              <a:buAutoNum type="arabicPeriod"/>
            </a:pPr>
            <a:r>
              <a:rPr lang="en-PT" sz="1600" dirty="0"/>
              <a:t>WT 16hpi</a:t>
            </a:r>
          </a:p>
          <a:p>
            <a:pPr marL="342900" indent="-342900">
              <a:buFont typeface="+mj-lt"/>
              <a:buAutoNum type="arabicPeriod"/>
            </a:pPr>
            <a:r>
              <a:rPr lang="en-PT" sz="1600" dirty="0"/>
              <a:t>WT 16hpi mock</a:t>
            </a:r>
          </a:p>
          <a:p>
            <a:pPr marL="342900" indent="-342900">
              <a:buFont typeface="+mj-lt"/>
              <a:buAutoNum type="arabicPeriod"/>
            </a:pPr>
            <a:r>
              <a:rPr lang="en-PT" sz="1600" dirty="0"/>
              <a:t>DN 16hpi</a:t>
            </a:r>
          </a:p>
          <a:p>
            <a:pPr marL="342900" indent="-342900">
              <a:buFont typeface="+mj-lt"/>
              <a:buAutoNum type="arabicPeriod"/>
            </a:pPr>
            <a:r>
              <a:rPr lang="en-PT" sz="1600" dirty="0"/>
              <a:t>DN 16hpi mock</a:t>
            </a:r>
          </a:p>
          <a:p>
            <a:pPr marL="342900" indent="-342900">
              <a:buFont typeface="+mj-lt"/>
              <a:buAutoNum type="arabicPeriod"/>
            </a:pPr>
            <a:r>
              <a:rPr lang="en-PT" sz="1600" dirty="0"/>
              <a:t>DN 16hpi</a:t>
            </a:r>
          </a:p>
          <a:p>
            <a:pPr marL="342900" indent="-342900">
              <a:buFont typeface="+mj-lt"/>
              <a:buAutoNum type="arabicPeriod"/>
            </a:pPr>
            <a:r>
              <a:rPr lang="en-PT" sz="1600" dirty="0"/>
              <a:t>DN 16hpi mock</a:t>
            </a:r>
          </a:p>
          <a:p>
            <a:pPr marL="342900" indent="-342900">
              <a:buFont typeface="+mj-lt"/>
              <a:buAutoNum type="arabicPeriod"/>
            </a:pPr>
            <a:endParaRPr lang="en-PT" sz="1600" dirty="0"/>
          </a:p>
          <a:p>
            <a:pPr marL="342900" indent="-342900">
              <a:buFont typeface="+mj-lt"/>
              <a:buAutoNum type="arabicPeriod"/>
            </a:pPr>
            <a:endParaRPr lang="en-PT" sz="1600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C06FCDFC-021E-3ACD-BE69-66EB9E2A7454}"/>
              </a:ext>
            </a:extLst>
          </p:cNvPr>
          <p:cNvSpPr txBox="1"/>
          <p:nvPr/>
        </p:nvSpPr>
        <p:spPr>
          <a:xfrm>
            <a:off x="7066868" y="1395041"/>
            <a:ext cx="53572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sz="1600" dirty="0"/>
              <a:t>PB2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23E9724E-3E30-B390-E97F-24526459961B}"/>
              </a:ext>
            </a:extLst>
          </p:cNvPr>
          <p:cNvSpPr txBox="1"/>
          <p:nvPr/>
        </p:nvSpPr>
        <p:spPr>
          <a:xfrm>
            <a:off x="7106384" y="1990144"/>
            <a:ext cx="4475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sz="1600" dirty="0"/>
              <a:t>NP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A0BE1291-FAD9-EA51-F47B-89091A00B9DE}"/>
              </a:ext>
            </a:extLst>
          </p:cNvPr>
          <p:cNvSpPr txBox="1"/>
          <p:nvPr/>
        </p:nvSpPr>
        <p:spPr>
          <a:xfrm>
            <a:off x="7022785" y="5093265"/>
            <a:ext cx="6415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sz="1600" dirty="0"/>
              <a:t>Actin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FE41B7E4-4C4C-0C7C-98E8-93D21421B143}"/>
              </a:ext>
            </a:extLst>
          </p:cNvPr>
          <p:cNvSpPr txBox="1"/>
          <p:nvPr/>
        </p:nvSpPr>
        <p:spPr>
          <a:xfrm>
            <a:off x="7104781" y="2565014"/>
            <a:ext cx="45076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sz="1600" dirty="0"/>
              <a:t>HA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8D6CBC3D-81CC-3301-F344-6AC47B8859F6}"/>
              </a:ext>
            </a:extLst>
          </p:cNvPr>
          <p:cNvSpPr txBox="1"/>
          <p:nvPr/>
        </p:nvSpPr>
        <p:spPr>
          <a:xfrm>
            <a:off x="7066868" y="3219791"/>
            <a:ext cx="55335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sz="1600" dirty="0"/>
              <a:t>NS1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00CEE1BD-9ADA-16D0-E3F5-5C81C110215E}"/>
              </a:ext>
            </a:extLst>
          </p:cNvPr>
          <p:cNvSpPr txBox="1"/>
          <p:nvPr/>
        </p:nvSpPr>
        <p:spPr>
          <a:xfrm>
            <a:off x="7102376" y="4433247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sz="1600" dirty="0"/>
              <a:t>M2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FBF8331E-4B37-8D38-FF99-6632E2BED4A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923966" y="1997306"/>
            <a:ext cx="3905744" cy="2988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3F37A605-DF1E-3C22-5FCA-C92BF28D837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918016" y="3173080"/>
            <a:ext cx="3917644" cy="36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B39F2C2F-514F-1F94-AA29-3B2CBB31CFE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923966" y="1418717"/>
            <a:ext cx="3905744" cy="30210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A324B4E4-1B03-9641-BA59-4AE28FB80DE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846438" y="2572593"/>
            <a:ext cx="4060800" cy="324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D395CB03-63CC-227C-08C3-D415A01A4294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808838" y="4428054"/>
            <a:ext cx="4136001" cy="396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5C2D7C8B-76C9-A2E5-7274-AA3709148F06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846438" y="5100542"/>
            <a:ext cx="4060800" cy="324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980BB811-6D32-836B-4CC5-752C7DD74782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921026" y="3809567"/>
            <a:ext cx="3911625" cy="342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1" name="TextBox 30">
            <a:extLst>
              <a:ext uri="{FF2B5EF4-FFF2-40B4-BE49-F238E27FC236}">
                <a16:creationId xmlns:a16="http://schemas.microsoft.com/office/drawing/2014/main" id="{94ADAE59-9336-4822-EACA-98E4B9BCE12A}"/>
              </a:ext>
            </a:extLst>
          </p:cNvPr>
          <p:cNvSpPr txBox="1"/>
          <p:nvPr/>
        </p:nvSpPr>
        <p:spPr>
          <a:xfrm>
            <a:off x="7115759" y="3847360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sz="1600" dirty="0"/>
              <a:t>M1</a:t>
            </a:r>
          </a:p>
        </p:txBody>
      </p:sp>
      <p:pic>
        <p:nvPicPr>
          <p:cNvPr id="33" name="Picture 32">
            <a:extLst>
              <a:ext uri="{FF2B5EF4-FFF2-40B4-BE49-F238E27FC236}">
                <a16:creationId xmlns:a16="http://schemas.microsoft.com/office/drawing/2014/main" id="{20EB9BA4-2FCA-18EA-8160-27C91579E4F7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7717838" y="5065571"/>
            <a:ext cx="4064310" cy="45159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5" name="Picture 34">
            <a:extLst>
              <a:ext uri="{FF2B5EF4-FFF2-40B4-BE49-F238E27FC236}">
                <a16:creationId xmlns:a16="http://schemas.microsoft.com/office/drawing/2014/main" id="{DACD72ED-BB70-BB31-F39C-BC3E0E101DCE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7717838" y="2559381"/>
            <a:ext cx="4064310" cy="45159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9" name="Picture 38">
            <a:extLst>
              <a:ext uri="{FF2B5EF4-FFF2-40B4-BE49-F238E27FC236}">
                <a16:creationId xmlns:a16="http://schemas.microsoft.com/office/drawing/2014/main" id="{956DB007-D7AE-762C-34E2-72D2DAA5C1BA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7717838" y="4439025"/>
            <a:ext cx="4064310" cy="45159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1" name="Picture 40">
            <a:extLst>
              <a:ext uri="{FF2B5EF4-FFF2-40B4-BE49-F238E27FC236}">
                <a16:creationId xmlns:a16="http://schemas.microsoft.com/office/drawing/2014/main" id="{696CDE25-E7DB-7895-C6E7-23EA7D01ADBF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7717838" y="1932833"/>
            <a:ext cx="4064310" cy="45159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3" name="Picture 42">
            <a:extLst>
              <a:ext uri="{FF2B5EF4-FFF2-40B4-BE49-F238E27FC236}">
                <a16:creationId xmlns:a16="http://schemas.microsoft.com/office/drawing/2014/main" id="{B4B78385-7EFC-DF0A-A8EC-B6724C8A2A6B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7717838" y="3185929"/>
            <a:ext cx="4064310" cy="45159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5" name="Picture 44">
            <a:extLst>
              <a:ext uri="{FF2B5EF4-FFF2-40B4-BE49-F238E27FC236}">
                <a16:creationId xmlns:a16="http://schemas.microsoft.com/office/drawing/2014/main" id="{40B2D4DF-7CFF-9BF4-97AD-A74C90EC4928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7717838" y="1306285"/>
            <a:ext cx="4064310" cy="45159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7" name="Picture 46">
            <a:extLst>
              <a:ext uri="{FF2B5EF4-FFF2-40B4-BE49-F238E27FC236}">
                <a16:creationId xmlns:a16="http://schemas.microsoft.com/office/drawing/2014/main" id="{FDF92DA6-2072-6CED-F639-5C63E0D1CEB9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7717838" y="3812477"/>
            <a:ext cx="4064310" cy="45159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8" name="TextBox 47">
            <a:extLst>
              <a:ext uri="{FF2B5EF4-FFF2-40B4-BE49-F238E27FC236}">
                <a16:creationId xmlns:a16="http://schemas.microsoft.com/office/drawing/2014/main" id="{5AE0ED4E-01B1-3C3A-6DE4-C1C49867D8A2}"/>
              </a:ext>
            </a:extLst>
          </p:cNvPr>
          <p:cNvSpPr txBox="1"/>
          <p:nvPr/>
        </p:nvSpPr>
        <p:spPr>
          <a:xfrm>
            <a:off x="4125686" y="5919220"/>
            <a:ext cx="1489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E</a:t>
            </a:r>
            <a:r>
              <a:rPr lang="en-PT" dirty="0"/>
              <a:t>xperiment 1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413D245A-4859-E750-F8A5-D8070A71D368}"/>
              </a:ext>
            </a:extLst>
          </p:cNvPr>
          <p:cNvSpPr txBox="1"/>
          <p:nvPr/>
        </p:nvSpPr>
        <p:spPr>
          <a:xfrm>
            <a:off x="9005238" y="5919220"/>
            <a:ext cx="1489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E</a:t>
            </a:r>
            <a:r>
              <a:rPr lang="en-PT" dirty="0"/>
              <a:t>xperiment 2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4FBCBCDF-2DA9-D79B-A580-23DDA6BBAC30}"/>
              </a:ext>
            </a:extLst>
          </p:cNvPr>
          <p:cNvSpPr txBox="1"/>
          <p:nvPr/>
        </p:nvSpPr>
        <p:spPr>
          <a:xfrm>
            <a:off x="2808838" y="5417589"/>
            <a:ext cx="42675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  1    2    3    4     5     6    7     8     9   10  11  12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F4AF7DB4-3640-D74A-DCC2-907BCD99AC95}"/>
              </a:ext>
            </a:extLst>
          </p:cNvPr>
          <p:cNvSpPr txBox="1"/>
          <p:nvPr/>
        </p:nvSpPr>
        <p:spPr>
          <a:xfrm>
            <a:off x="7674388" y="5490593"/>
            <a:ext cx="42675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PT" dirty="0"/>
              <a:t>  1    2    3     4     5     6    7     8     9   10  11  12</a:t>
            </a:r>
          </a:p>
        </p:txBody>
      </p:sp>
    </p:spTree>
    <p:extLst>
      <p:ext uri="{BB962C8B-B14F-4D97-AF65-F5344CB8AC3E}">
        <p14:creationId xmlns:p14="http://schemas.microsoft.com/office/powerpoint/2010/main" val="26000911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0</TotalTime>
  <Words>645</Words>
  <Application>Microsoft Macintosh PowerPoint</Application>
  <PresentationFormat>Widescreen</PresentationFormat>
  <Paragraphs>244</Paragraphs>
  <Slides>18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8</vt:i4>
      </vt:variant>
    </vt:vector>
  </HeadingPairs>
  <TitlesOfParts>
    <vt:vector size="22" baseType="lpstr">
      <vt:lpstr>Aptos</vt:lpstr>
      <vt:lpstr>Aptos Display</vt:lpstr>
      <vt:lpstr>Arial</vt:lpstr>
      <vt:lpstr>Office Theme</vt:lpstr>
      <vt:lpstr>A549 cell line WBs</vt:lpstr>
      <vt:lpstr>Replicate 1 and 2, 4hpi and 8hpi timepoints</vt:lpstr>
      <vt:lpstr>Rep 1 and 2 - order in previous slide</vt:lpstr>
      <vt:lpstr>Rep 1 and 2 – NS1 – same gel as HA,actin </vt:lpstr>
      <vt:lpstr>PowerPoint Presentation</vt:lpstr>
      <vt:lpstr>Replicate 1 and 2, 4hpi and 8hpi timepoints</vt:lpstr>
      <vt:lpstr>Rep 1 and 2 4h 8h – M2</vt:lpstr>
      <vt:lpstr>Rep 1 and 2 4h 8h – M1</vt:lpstr>
      <vt:lpstr>Replicate 1 and 2, 12hpi and 16hpi timepoints</vt:lpstr>
      <vt:lpstr>Replicate 1     Replicate 2</vt:lpstr>
      <vt:lpstr>M1</vt:lpstr>
      <vt:lpstr>Replicate 3</vt:lpstr>
      <vt:lpstr>Inf and mocks – R3</vt:lpstr>
      <vt:lpstr>Inf and mocks – R3</vt:lpstr>
      <vt:lpstr>M1 on left, NS1 on right – separated channels</vt:lpstr>
      <vt:lpstr>MDCK-HA WBs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idan O'Riain</dc:creator>
  <cp:lastModifiedBy>Aidan O'Riain</cp:lastModifiedBy>
  <cp:revision>23</cp:revision>
  <dcterms:created xsi:type="dcterms:W3CDTF">2025-09-17T13:44:33Z</dcterms:created>
  <dcterms:modified xsi:type="dcterms:W3CDTF">2025-09-17T15:55:08Z</dcterms:modified>
</cp:coreProperties>
</file>